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1"/>
  </p:notesMasterIdLst>
  <p:sldIdLst>
    <p:sldId id="271" r:id="rId2"/>
    <p:sldId id="266" r:id="rId3"/>
    <p:sldId id="264" r:id="rId4"/>
    <p:sldId id="272" r:id="rId5"/>
    <p:sldId id="270" r:id="rId6"/>
    <p:sldId id="268" r:id="rId7"/>
    <p:sldId id="269" r:id="rId8"/>
    <p:sldId id="261" r:id="rId9"/>
    <p:sldId id="273" r:id="rId10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37FF"/>
    <a:srgbClr val="008F51"/>
    <a:srgbClr val="37A86D"/>
    <a:srgbClr val="941100"/>
    <a:srgbClr val="89D761"/>
    <a:srgbClr val="F8E32F"/>
    <a:srgbClr val="541263"/>
    <a:srgbClr val="942193"/>
    <a:srgbClr val="008E4F"/>
    <a:srgbClr val="9337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564"/>
    <p:restoredTop sz="94658"/>
  </p:normalViewPr>
  <p:slideViewPr>
    <p:cSldViewPr snapToGrid="0">
      <p:cViewPr varScale="1">
        <p:scale>
          <a:sx n="120" d="100"/>
          <a:sy n="120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ber, Charlie" userId="a4408506-200b-48fd-8fce-b836ccf79d22" providerId="ADAL" clId="{4948E1E4-26F2-F34E-9E67-BE929835C6A7}"/>
    <pc:docChg chg="undo redo custSel modSld">
      <pc:chgData name="Arber, Charlie" userId="a4408506-200b-48fd-8fce-b836ccf79d22" providerId="ADAL" clId="{4948E1E4-26F2-F34E-9E67-BE929835C6A7}" dt="2025-05-19T09:18:56.964" v="454" actId="1036"/>
      <pc:docMkLst>
        <pc:docMk/>
      </pc:docMkLst>
      <pc:sldChg chg="addSp modSp mod">
        <pc:chgData name="Arber, Charlie" userId="a4408506-200b-48fd-8fce-b836ccf79d22" providerId="ADAL" clId="{4948E1E4-26F2-F34E-9E67-BE929835C6A7}" dt="2025-05-06T10:48:20.172" v="393" actId="1036"/>
        <pc:sldMkLst>
          <pc:docMk/>
          <pc:sldMk cId="2550048449" sldId="261"/>
        </pc:sldMkLst>
        <pc:spChg chg="add mod">
          <ac:chgData name="Arber, Charlie" userId="a4408506-200b-48fd-8fce-b836ccf79d22" providerId="ADAL" clId="{4948E1E4-26F2-F34E-9E67-BE929835C6A7}" dt="2025-05-06T10:48:20.172" v="393" actId="1036"/>
          <ac:spMkLst>
            <pc:docMk/>
            <pc:sldMk cId="2550048449" sldId="261"/>
            <ac:spMk id="16" creationId="{BFFB6CA3-0CC9-39CC-FA76-EF1316C0419E}"/>
          </ac:spMkLst>
        </pc:spChg>
        <pc:spChg chg="add mod">
          <ac:chgData name="Arber, Charlie" userId="a4408506-200b-48fd-8fce-b836ccf79d22" providerId="ADAL" clId="{4948E1E4-26F2-F34E-9E67-BE929835C6A7}" dt="2025-05-06T10:48:20.172" v="393" actId="1036"/>
          <ac:spMkLst>
            <pc:docMk/>
            <pc:sldMk cId="2550048449" sldId="261"/>
            <ac:spMk id="17" creationId="{4EF1C7E3-83D3-3D2D-4360-08F7349CADC6}"/>
          </ac:spMkLst>
        </pc:sp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3" creationId="{FBA3489C-A8D8-1EE3-766F-13EBF496A37E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6" creationId="{C3C30D00-30E6-AF80-BE3F-AD487E6B9545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7" creationId="{808FC227-766D-8814-6530-8C654572C555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8" creationId="{08ED6297-3B44-A13A-E5E0-2243F4625732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11" creationId="{CD3366BC-6C9E-9A12-2FF0-F7C6F2CDC802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12" creationId="{C49C90A0-58CB-7D38-1C73-A9E86278EEBA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14" creationId="{225976A4-04B0-C3C6-0885-211F0D3CE7B4}"/>
          </ac:picMkLst>
        </pc:picChg>
        <pc:picChg chg="mod">
          <ac:chgData name="Arber, Charlie" userId="a4408506-200b-48fd-8fce-b836ccf79d22" providerId="ADAL" clId="{4948E1E4-26F2-F34E-9E67-BE929835C6A7}" dt="2025-05-06T10:48:20.172" v="393" actId="1036"/>
          <ac:picMkLst>
            <pc:docMk/>
            <pc:sldMk cId="2550048449" sldId="261"/>
            <ac:picMk id="15" creationId="{02F0F4E6-F3C7-079F-9E9F-A6DDFE7DCBDD}"/>
          </ac:picMkLst>
        </pc:picChg>
      </pc:sldChg>
      <pc:sldChg chg="addSp delSp modSp mod">
        <pc:chgData name="Arber, Charlie" userId="a4408506-200b-48fd-8fce-b836ccf79d22" providerId="ADAL" clId="{4948E1E4-26F2-F34E-9E67-BE929835C6A7}" dt="2025-05-01T11:41:38.266" v="344" actId="1076"/>
        <pc:sldMkLst>
          <pc:docMk/>
          <pc:sldMk cId="1192687595" sldId="264"/>
        </pc:sldMkLst>
        <pc:spChg chg="add mod">
          <ac:chgData name="Arber, Charlie" userId="a4408506-200b-48fd-8fce-b836ccf79d22" providerId="ADAL" clId="{4948E1E4-26F2-F34E-9E67-BE929835C6A7}" dt="2025-05-01T11:39:47.346" v="316" actId="1035"/>
          <ac:spMkLst>
            <pc:docMk/>
            <pc:sldMk cId="1192687595" sldId="264"/>
            <ac:spMk id="7" creationId="{BBC180B7-8086-8706-0002-A89C59AE0B65}"/>
          </ac:spMkLst>
        </pc:spChg>
        <pc:spChg chg="add mod">
          <ac:chgData name="Arber, Charlie" userId="a4408506-200b-48fd-8fce-b836ccf79d22" providerId="ADAL" clId="{4948E1E4-26F2-F34E-9E67-BE929835C6A7}" dt="2025-05-01T11:40:37.357" v="337" actId="1038"/>
          <ac:spMkLst>
            <pc:docMk/>
            <pc:sldMk cId="1192687595" sldId="264"/>
            <ac:spMk id="9" creationId="{B8BAA2BA-7EB3-2AF5-4A03-8985E23F4C14}"/>
          </ac:spMkLst>
        </pc:spChg>
        <pc:spChg chg="mod">
          <ac:chgData name="Arber, Charlie" userId="a4408506-200b-48fd-8fce-b836ccf79d22" providerId="ADAL" clId="{4948E1E4-26F2-F34E-9E67-BE929835C6A7}" dt="2025-05-01T11:39:43.490" v="314" actId="1035"/>
          <ac:spMkLst>
            <pc:docMk/>
            <pc:sldMk cId="1192687595" sldId="264"/>
            <ac:spMk id="10" creationId="{732E3810-4A41-58DA-E115-5768D86FC377}"/>
          </ac:spMkLst>
        </pc:spChg>
        <pc:spChg chg="mod">
          <ac:chgData name="Arber, Charlie" userId="a4408506-200b-48fd-8fce-b836ccf79d22" providerId="ADAL" clId="{4948E1E4-26F2-F34E-9E67-BE929835C6A7}" dt="2025-05-01T11:39:43.490" v="314" actId="1035"/>
          <ac:spMkLst>
            <pc:docMk/>
            <pc:sldMk cId="1192687595" sldId="264"/>
            <ac:spMk id="12" creationId="{83D0EA7F-9CA5-A285-2779-F1B7ED5A9D46}"/>
          </ac:spMkLst>
        </pc:spChg>
        <pc:spChg chg="mod">
          <ac:chgData name="Arber, Charlie" userId="a4408506-200b-48fd-8fce-b836ccf79d22" providerId="ADAL" clId="{4948E1E4-26F2-F34E-9E67-BE929835C6A7}" dt="2025-05-01T11:39:43.490" v="314" actId="1035"/>
          <ac:spMkLst>
            <pc:docMk/>
            <pc:sldMk cId="1192687595" sldId="264"/>
            <ac:spMk id="13" creationId="{F0BDFE58-20D7-6A0C-8340-D66AF7B2D012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18" creationId="{358D7535-DB15-171C-AA4E-324FE9CAA72E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19" creationId="{F8B95973-056A-2D02-4C8E-32A5DD9283A4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0" creationId="{BAC3CE31-FBDC-1A77-9737-56E11270F70E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2" creationId="{0B50A50E-C642-08D2-EEC2-3312836BC907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3" creationId="{F5519BEE-FB12-D86F-5C61-21A7C7C17267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5" creationId="{3218476C-BDC4-2315-CA24-DD22D531A5B8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7" creationId="{3B0DB3F5-F54E-2BA0-6A1E-883CF9C06718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29" creationId="{4880D57F-E98F-FDD7-48E8-D7C0546A6B58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35" creationId="{D9C8DD15-4993-CCFD-06F4-5A03680568CA}"/>
          </ac:spMkLst>
        </pc:spChg>
        <pc:spChg chg="mod">
          <ac:chgData name="Arber, Charlie" userId="a4408506-200b-48fd-8fce-b836ccf79d22" providerId="ADAL" clId="{4948E1E4-26F2-F34E-9E67-BE929835C6A7}" dt="2025-05-01T11:41:00.710" v="338"/>
          <ac:spMkLst>
            <pc:docMk/>
            <pc:sldMk cId="1192687595" sldId="264"/>
            <ac:spMk id="36" creationId="{E0F16F21-3CA3-36D6-7FD5-452C3F77C519}"/>
          </ac:spMkLst>
        </pc:spChg>
        <pc:grpChg chg="mod">
          <ac:chgData name="Arber, Charlie" userId="a4408506-200b-48fd-8fce-b836ccf79d22" providerId="ADAL" clId="{4948E1E4-26F2-F34E-9E67-BE929835C6A7}" dt="2025-05-01T11:41:04.368" v="339" actId="1076"/>
          <ac:grpSpMkLst>
            <pc:docMk/>
            <pc:sldMk cId="1192687595" sldId="264"/>
            <ac:grpSpMk id="16" creationId="{46AB14F5-D360-09F9-1D9D-A5423BE3DF3B}"/>
          </ac:grpSpMkLst>
        </pc:grpChg>
        <pc:picChg chg="mod">
          <ac:chgData name="Arber, Charlie" userId="a4408506-200b-48fd-8fce-b836ccf79d22" providerId="ADAL" clId="{4948E1E4-26F2-F34E-9E67-BE929835C6A7}" dt="2025-05-01T11:39:43.490" v="314" actId="1035"/>
          <ac:picMkLst>
            <pc:docMk/>
            <pc:sldMk cId="1192687595" sldId="264"/>
            <ac:picMk id="2" creationId="{0B5C68BB-0AFA-67FE-2D1C-420529AE2F9D}"/>
          </ac:picMkLst>
        </pc:picChg>
        <pc:picChg chg="mod">
          <ac:chgData name="Arber, Charlie" userId="a4408506-200b-48fd-8fce-b836ccf79d22" providerId="ADAL" clId="{4948E1E4-26F2-F34E-9E67-BE929835C6A7}" dt="2025-05-01T11:39:43.490" v="314" actId="1035"/>
          <ac:picMkLst>
            <pc:docMk/>
            <pc:sldMk cId="1192687595" sldId="264"/>
            <ac:picMk id="6" creationId="{78BC54FC-A73A-6189-B9E6-8F97140E2390}"/>
          </ac:picMkLst>
        </pc:picChg>
        <pc:picChg chg="mod">
          <ac:chgData name="Arber, Charlie" userId="a4408506-200b-48fd-8fce-b836ccf79d22" providerId="ADAL" clId="{4948E1E4-26F2-F34E-9E67-BE929835C6A7}" dt="2025-05-01T11:39:43.490" v="314" actId="1035"/>
          <ac:picMkLst>
            <pc:docMk/>
            <pc:sldMk cId="1192687595" sldId="264"/>
            <ac:picMk id="8" creationId="{14F68638-645B-C10A-3696-F55A3E8CD2AC}"/>
          </ac:picMkLst>
        </pc:picChg>
        <pc:picChg chg="add mod">
          <ac:chgData name="Arber, Charlie" userId="a4408506-200b-48fd-8fce-b836ccf79d22" providerId="ADAL" clId="{4948E1E4-26F2-F34E-9E67-BE929835C6A7}" dt="2025-05-01T11:41:14.911" v="341" actId="1076"/>
          <ac:picMkLst>
            <pc:docMk/>
            <pc:sldMk cId="1192687595" sldId="264"/>
            <ac:picMk id="14" creationId="{55A9BD21-B861-C0C2-000D-DBD90BB9839A}"/>
          </ac:picMkLst>
        </pc:picChg>
        <pc:picChg chg="add mod">
          <ac:chgData name="Arber, Charlie" userId="a4408506-200b-48fd-8fce-b836ccf79d22" providerId="ADAL" clId="{4948E1E4-26F2-F34E-9E67-BE929835C6A7}" dt="2025-05-01T11:41:38.266" v="344" actId="1076"/>
          <ac:picMkLst>
            <pc:docMk/>
            <pc:sldMk cId="1192687595" sldId="264"/>
            <ac:picMk id="15" creationId="{021FD1F3-89DF-7705-E020-E550FDBC6B5A}"/>
          </ac:picMkLst>
        </pc:picChg>
      </pc:sldChg>
      <pc:sldChg chg="addSp delSp modSp mod">
        <pc:chgData name="Arber, Charlie" userId="a4408506-200b-48fd-8fce-b836ccf79d22" providerId="ADAL" clId="{4948E1E4-26F2-F34E-9E67-BE929835C6A7}" dt="2025-05-19T09:18:56.964" v="454" actId="1036"/>
        <pc:sldMkLst>
          <pc:docMk/>
          <pc:sldMk cId="2203610160" sldId="272"/>
        </pc:sldMkLst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2" creationId="{EC5E64B6-F9F4-39EE-A37A-7B64F91702A8}"/>
          </ac:spMkLst>
        </pc:spChg>
        <pc:spChg chg="add mod">
          <ac:chgData name="Arber, Charlie" userId="a4408506-200b-48fd-8fce-b836ccf79d22" providerId="ADAL" clId="{4948E1E4-26F2-F34E-9E67-BE929835C6A7}" dt="2025-05-01T10:18:59.895" v="33" actId="1076"/>
          <ac:spMkLst>
            <pc:docMk/>
            <pc:sldMk cId="2203610160" sldId="272"/>
            <ac:spMk id="5" creationId="{E3C40C47-0845-1F0D-D745-9439955F9C8B}"/>
          </ac:spMkLst>
        </pc:spChg>
        <pc:spChg chg="add mod">
          <ac:chgData name="Arber, Charlie" userId="a4408506-200b-48fd-8fce-b836ccf79d22" providerId="ADAL" clId="{4948E1E4-26F2-F34E-9E67-BE929835C6A7}" dt="2025-05-01T10:19:04.336" v="35" actId="1076"/>
          <ac:spMkLst>
            <pc:docMk/>
            <pc:sldMk cId="2203610160" sldId="272"/>
            <ac:spMk id="10" creationId="{F09AE50E-765E-91A2-7E65-17EFA5552774}"/>
          </ac:spMkLst>
        </pc:spChg>
        <pc:spChg chg="add mod">
          <ac:chgData name="Arber, Charlie" userId="a4408506-200b-48fd-8fce-b836ccf79d22" providerId="ADAL" clId="{4948E1E4-26F2-F34E-9E67-BE929835C6A7}" dt="2025-05-01T10:19:46.117" v="57" actId="1076"/>
          <ac:spMkLst>
            <pc:docMk/>
            <pc:sldMk cId="2203610160" sldId="272"/>
            <ac:spMk id="14" creationId="{F66DE50C-112D-5A12-5AD4-DAA260DF07FD}"/>
          </ac:spMkLst>
        </pc:spChg>
        <pc:spChg chg="mod">
          <ac:chgData name="Arber, Charlie" userId="a4408506-200b-48fd-8fce-b836ccf79d22" providerId="ADAL" clId="{4948E1E4-26F2-F34E-9E67-BE929835C6A7}" dt="2025-05-01T10:29:38.636" v="286" actId="1036"/>
          <ac:spMkLst>
            <pc:docMk/>
            <pc:sldMk cId="2203610160" sldId="272"/>
            <ac:spMk id="16" creationId="{7029036A-2E66-DB25-6B19-CCDE5337907B}"/>
          </ac:spMkLst>
        </pc:spChg>
        <pc:spChg chg="add mod">
          <ac:chgData name="Arber, Charlie" userId="a4408506-200b-48fd-8fce-b836ccf79d22" providerId="ADAL" clId="{4948E1E4-26F2-F34E-9E67-BE929835C6A7}" dt="2025-05-01T10:19:19.934" v="46" actId="1038"/>
          <ac:spMkLst>
            <pc:docMk/>
            <pc:sldMk cId="2203610160" sldId="272"/>
            <ac:spMk id="20" creationId="{F4815F47-F539-20F3-736B-8906A582F416}"/>
          </ac:spMkLst>
        </pc:spChg>
        <pc:spChg chg="add mod">
          <ac:chgData name="Arber, Charlie" userId="a4408506-200b-48fd-8fce-b836ccf79d22" providerId="ADAL" clId="{4948E1E4-26F2-F34E-9E67-BE929835C6A7}" dt="2025-05-01T10:19:26.108" v="53" actId="1037"/>
          <ac:spMkLst>
            <pc:docMk/>
            <pc:sldMk cId="2203610160" sldId="272"/>
            <ac:spMk id="21" creationId="{7DE6331D-7B9E-4C23-A086-A01AC16AF509}"/>
          </ac:spMkLst>
        </pc:spChg>
        <pc:spChg chg="add mod">
          <ac:chgData name="Arber, Charlie" userId="a4408506-200b-48fd-8fce-b836ccf79d22" providerId="ADAL" clId="{4948E1E4-26F2-F34E-9E67-BE929835C6A7}" dt="2025-05-01T10:20:05.923" v="64" actId="1076"/>
          <ac:spMkLst>
            <pc:docMk/>
            <pc:sldMk cId="2203610160" sldId="272"/>
            <ac:spMk id="22" creationId="{50ED8F49-A18E-857F-7371-8120B717BBB1}"/>
          </ac:spMkLst>
        </pc:spChg>
        <pc:spChg chg="add mod">
          <ac:chgData name="Arber, Charlie" userId="a4408506-200b-48fd-8fce-b836ccf79d22" providerId="ADAL" clId="{4948E1E4-26F2-F34E-9E67-BE929835C6A7}" dt="2025-05-01T10:20:22.183" v="71" actId="1076"/>
          <ac:spMkLst>
            <pc:docMk/>
            <pc:sldMk cId="2203610160" sldId="272"/>
            <ac:spMk id="23" creationId="{FE276D1F-1847-7739-22DC-7373A36FEFC1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24" creationId="{43107D48-F57D-B422-28E7-3AB45A5B3948}"/>
          </ac:spMkLst>
        </pc:spChg>
        <pc:spChg chg="add mod">
          <ac:chgData name="Arber, Charlie" userId="a4408506-200b-48fd-8fce-b836ccf79d22" providerId="ADAL" clId="{4948E1E4-26F2-F34E-9E67-BE929835C6A7}" dt="2025-05-01T10:20:34.216" v="75" actId="1076"/>
          <ac:spMkLst>
            <pc:docMk/>
            <pc:sldMk cId="2203610160" sldId="272"/>
            <ac:spMk id="25" creationId="{D8B20E97-5675-1E72-159B-E504B16878A0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26" creationId="{F439D488-F2DB-D497-1256-D243961056E6}"/>
          </ac:spMkLst>
        </pc:spChg>
        <pc:spChg chg="add mod">
          <ac:chgData name="Arber, Charlie" userId="a4408506-200b-48fd-8fce-b836ccf79d22" providerId="ADAL" clId="{4948E1E4-26F2-F34E-9E67-BE929835C6A7}" dt="2025-05-01T10:21:15.615" v="87" actId="207"/>
          <ac:spMkLst>
            <pc:docMk/>
            <pc:sldMk cId="2203610160" sldId="272"/>
            <ac:spMk id="27" creationId="{3766C41A-CE32-C4D1-714A-875E981FF2EA}"/>
          </ac:spMkLst>
        </pc:spChg>
        <pc:spChg chg="add mod">
          <ac:chgData name="Arber, Charlie" userId="a4408506-200b-48fd-8fce-b836ccf79d22" providerId="ADAL" clId="{4948E1E4-26F2-F34E-9E67-BE929835C6A7}" dt="2025-05-01T10:21:29.413" v="91" actId="1076"/>
          <ac:spMkLst>
            <pc:docMk/>
            <pc:sldMk cId="2203610160" sldId="272"/>
            <ac:spMk id="28" creationId="{31134BBE-D749-E0E3-7E84-F31D363A225C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29" creationId="{60F0E33C-990A-BB0E-0A2E-91A217E893DF}"/>
          </ac:spMkLst>
        </pc:spChg>
        <pc:spChg chg="add mod">
          <ac:chgData name="Arber, Charlie" userId="a4408506-200b-48fd-8fce-b836ccf79d22" providerId="ADAL" clId="{4948E1E4-26F2-F34E-9E67-BE929835C6A7}" dt="2025-05-01T10:21:39.016" v="93" actId="1076"/>
          <ac:spMkLst>
            <pc:docMk/>
            <pc:sldMk cId="2203610160" sldId="272"/>
            <ac:spMk id="30" creationId="{06DE5E85-80F2-99CA-1243-00C4EAF67F23}"/>
          </ac:spMkLst>
        </pc:spChg>
        <pc:spChg chg="add mod">
          <ac:chgData name="Arber, Charlie" userId="a4408506-200b-48fd-8fce-b836ccf79d22" providerId="ADAL" clId="{4948E1E4-26F2-F34E-9E67-BE929835C6A7}" dt="2025-05-01T10:21:47.282" v="95" actId="1076"/>
          <ac:spMkLst>
            <pc:docMk/>
            <pc:sldMk cId="2203610160" sldId="272"/>
            <ac:spMk id="31" creationId="{4E3AE2BB-FAF1-CDCC-87A7-954AC8042162}"/>
          </ac:spMkLst>
        </pc:spChg>
        <pc:spChg chg="add mod">
          <ac:chgData name="Arber, Charlie" userId="a4408506-200b-48fd-8fce-b836ccf79d22" providerId="ADAL" clId="{4948E1E4-26F2-F34E-9E67-BE929835C6A7}" dt="2025-05-01T10:21:54.377" v="97" actId="1076"/>
          <ac:spMkLst>
            <pc:docMk/>
            <pc:sldMk cId="2203610160" sldId="272"/>
            <ac:spMk id="32" creationId="{8738369F-AC95-9FBA-4E7F-DFE378639742}"/>
          </ac:spMkLst>
        </pc:spChg>
        <pc:spChg chg="add mod">
          <ac:chgData name="Arber, Charlie" userId="a4408506-200b-48fd-8fce-b836ccf79d22" providerId="ADAL" clId="{4948E1E4-26F2-F34E-9E67-BE929835C6A7}" dt="2025-05-01T10:21:58.529" v="99" actId="1076"/>
          <ac:spMkLst>
            <pc:docMk/>
            <pc:sldMk cId="2203610160" sldId="272"/>
            <ac:spMk id="33" creationId="{4CD7EBE7-4325-A278-3B6A-E956A44C0D5E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34" creationId="{8C9BAB3B-F627-0A4D-966F-1012573A7FA0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35" creationId="{53D3D7A3-0004-B934-2C52-82B0EFD82EC3}"/>
          </ac:spMkLst>
        </pc:spChg>
        <pc:spChg chg="add mod">
          <ac:chgData name="Arber, Charlie" userId="a4408506-200b-48fd-8fce-b836ccf79d22" providerId="ADAL" clId="{4948E1E4-26F2-F34E-9E67-BE929835C6A7}" dt="2025-05-01T10:22:30.211" v="119" actId="1076"/>
          <ac:spMkLst>
            <pc:docMk/>
            <pc:sldMk cId="2203610160" sldId="272"/>
            <ac:spMk id="36" creationId="{A2D802D9-B1C2-71A2-7B6A-94ED50EBA0C0}"/>
          </ac:spMkLst>
        </pc:spChg>
        <pc:spChg chg="add mod">
          <ac:chgData name="Arber, Charlie" userId="a4408506-200b-48fd-8fce-b836ccf79d22" providerId="ADAL" clId="{4948E1E4-26F2-F34E-9E67-BE929835C6A7}" dt="2025-05-01T10:22:34.741" v="121" actId="1076"/>
          <ac:spMkLst>
            <pc:docMk/>
            <pc:sldMk cId="2203610160" sldId="272"/>
            <ac:spMk id="37" creationId="{DC1E8F12-2C44-12D5-A34F-1FE437A8B4DB}"/>
          </ac:spMkLst>
        </pc:spChg>
        <pc:spChg chg="add mod">
          <ac:chgData name="Arber, Charlie" userId="a4408506-200b-48fd-8fce-b836ccf79d22" providerId="ADAL" clId="{4948E1E4-26F2-F34E-9E67-BE929835C6A7}" dt="2025-05-01T10:22:38.731" v="123" actId="1076"/>
          <ac:spMkLst>
            <pc:docMk/>
            <pc:sldMk cId="2203610160" sldId="272"/>
            <ac:spMk id="38" creationId="{73C71215-84FC-63AC-1841-4C7D43F66DAB}"/>
          </ac:spMkLst>
        </pc:spChg>
        <pc:spChg chg="add mod">
          <ac:chgData name="Arber, Charlie" userId="a4408506-200b-48fd-8fce-b836ccf79d22" providerId="ADAL" clId="{4948E1E4-26F2-F34E-9E67-BE929835C6A7}" dt="2025-05-01T10:22:42.270" v="125" actId="1076"/>
          <ac:spMkLst>
            <pc:docMk/>
            <pc:sldMk cId="2203610160" sldId="272"/>
            <ac:spMk id="39" creationId="{9B7CB8F8-EDB2-5532-7CE3-E4165C5259AF}"/>
          </ac:spMkLst>
        </pc:spChg>
        <pc:spChg chg="add mod">
          <ac:chgData name="Arber, Charlie" userId="a4408506-200b-48fd-8fce-b836ccf79d22" providerId="ADAL" clId="{4948E1E4-26F2-F34E-9E67-BE929835C6A7}" dt="2025-05-01T10:22:46.089" v="127" actId="1076"/>
          <ac:spMkLst>
            <pc:docMk/>
            <pc:sldMk cId="2203610160" sldId="272"/>
            <ac:spMk id="40" creationId="{1C4EE0A9-F6EA-0F2A-E5D9-43185BE94B81}"/>
          </ac:spMkLst>
        </pc:spChg>
        <pc:spChg chg="add mod">
          <ac:chgData name="Arber, Charlie" userId="a4408506-200b-48fd-8fce-b836ccf79d22" providerId="ADAL" clId="{4948E1E4-26F2-F34E-9E67-BE929835C6A7}" dt="2025-05-01T10:22:57.613" v="134" actId="1076"/>
          <ac:spMkLst>
            <pc:docMk/>
            <pc:sldMk cId="2203610160" sldId="272"/>
            <ac:spMk id="41" creationId="{11387D3B-CC2D-F1F6-3F47-E21D52FC1D9A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42" creationId="{E3B8701F-64FB-BB1A-F791-51683BFF2DC3}"/>
          </ac:spMkLst>
        </pc:spChg>
        <pc:spChg chg="add mod">
          <ac:chgData name="Arber, Charlie" userId="a4408506-200b-48fd-8fce-b836ccf79d22" providerId="ADAL" clId="{4948E1E4-26F2-F34E-9E67-BE929835C6A7}" dt="2025-05-01T10:23:06.166" v="138" actId="1076"/>
          <ac:spMkLst>
            <pc:docMk/>
            <pc:sldMk cId="2203610160" sldId="272"/>
            <ac:spMk id="43" creationId="{A7E7D719-2F08-584B-4EFF-A6D40BDF46FE}"/>
          </ac:spMkLst>
        </pc:spChg>
        <pc:spChg chg="add mod">
          <ac:chgData name="Arber, Charlie" userId="a4408506-200b-48fd-8fce-b836ccf79d22" providerId="ADAL" clId="{4948E1E4-26F2-F34E-9E67-BE929835C6A7}" dt="2025-05-01T10:23:11.701" v="140" actId="1076"/>
          <ac:spMkLst>
            <pc:docMk/>
            <pc:sldMk cId="2203610160" sldId="272"/>
            <ac:spMk id="44" creationId="{48B3EFD6-482C-D842-4FF0-F82DC00A74D0}"/>
          </ac:spMkLst>
        </pc:spChg>
        <pc:spChg chg="add mod">
          <ac:chgData name="Arber, Charlie" userId="a4408506-200b-48fd-8fce-b836ccf79d22" providerId="ADAL" clId="{4948E1E4-26F2-F34E-9E67-BE929835C6A7}" dt="2025-05-01T10:23:15.090" v="142" actId="1076"/>
          <ac:spMkLst>
            <pc:docMk/>
            <pc:sldMk cId="2203610160" sldId="272"/>
            <ac:spMk id="45" creationId="{F02EA13F-6E63-9090-11B9-055BEE1F17BB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46" creationId="{99E51061-C73C-BB7A-BA3F-6D6EC9589FDC}"/>
          </ac:spMkLst>
        </pc:spChg>
        <pc:spChg chg="add mod">
          <ac:chgData name="Arber, Charlie" userId="a4408506-200b-48fd-8fce-b836ccf79d22" providerId="ADAL" clId="{4948E1E4-26F2-F34E-9E67-BE929835C6A7}" dt="2025-05-01T10:23:46.635" v="146" actId="1076"/>
          <ac:spMkLst>
            <pc:docMk/>
            <pc:sldMk cId="2203610160" sldId="272"/>
            <ac:spMk id="47" creationId="{294BEF16-7D82-A4D0-F6FB-BFE97B24216E}"/>
          </ac:spMkLst>
        </pc:spChg>
        <pc:spChg chg="add mod">
          <ac:chgData name="Arber, Charlie" userId="a4408506-200b-48fd-8fce-b836ccf79d22" providerId="ADAL" clId="{4948E1E4-26F2-F34E-9E67-BE929835C6A7}" dt="2025-05-01T10:23:54.421" v="148" actId="1076"/>
          <ac:spMkLst>
            <pc:docMk/>
            <pc:sldMk cId="2203610160" sldId="272"/>
            <ac:spMk id="48" creationId="{84852571-D8C9-63EF-A9D6-C7B808E2B358}"/>
          </ac:spMkLst>
        </pc:spChg>
        <pc:spChg chg="add mod">
          <ac:chgData name="Arber, Charlie" userId="a4408506-200b-48fd-8fce-b836ccf79d22" providerId="ADAL" clId="{4948E1E4-26F2-F34E-9E67-BE929835C6A7}" dt="2025-05-01T10:24:52.815" v="156" actId="1076"/>
          <ac:spMkLst>
            <pc:docMk/>
            <pc:sldMk cId="2203610160" sldId="272"/>
            <ac:spMk id="49" creationId="{11D55465-CE25-778C-4B12-46527C5B27CD}"/>
          </ac:spMkLst>
        </pc:spChg>
        <pc:spChg chg="add mod">
          <ac:chgData name="Arber, Charlie" userId="a4408506-200b-48fd-8fce-b836ccf79d22" providerId="ADAL" clId="{4948E1E4-26F2-F34E-9E67-BE929835C6A7}" dt="2025-05-01T10:24:56.970" v="158" actId="1076"/>
          <ac:spMkLst>
            <pc:docMk/>
            <pc:sldMk cId="2203610160" sldId="272"/>
            <ac:spMk id="50" creationId="{4FA4C768-293D-B935-B1F7-51DA8359A0CC}"/>
          </ac:spMkLst>
        </pc:spChg>
        <pc:spChg chg="add mod">
          <ac:chgData name="Arber, Charlie" userId="a4408506-200b-48fd-8fce-b836ccf79d22" providerId="ADAL" clId="{4948E1E4-26F2-F34E-9E67-BE929835C6A7}" dt="2025-05-01T10:25:00.257" v="160" actId="1076"/>
          <ac:spMkLst>
            <pc:docMk/>
            <pc:sldMk cId="2203610160" sldId="272"/>
            <ac:spMk id="51" creationId="{745CE393-3796-1A6B-B318-3EF4B49FF415}"/>
          </ac:spMkLst>
        </pc:spChg>
        <pc:spChg chg="add mod">
          <ac:chgData name="Arber, Charlie" userId="a4408506-200b-48fd-8fce-b836ccf79d22" providerId="ADAL" clId="{4948E1E4-26F2-F34E-9E67-BE929835C6A7}" dt="2025-05-01T10:25:08.492" v="162" actId="1076"/>
          <ac:spMkLst>
            <pc:docMk/>
            <pc:sldMk cId="2203610160" sldId="272"/>
            <ac:spMk id="52" creationId="{A382EDBA-F6A6-40C5-6735-1CFDC388724D}"/>
          </ac:spMkLst>
        </pc:spChg>
        <pc:spChg chg="add mod">
          <ac:chgData name="Arber, Charlie" userId="a4408506-200b-48fd-8fce-b836ccf79d22" providerId="ADAL" clId="{4948E1E4-26F2-F34E-9E67-BE929835C6A7}" dt="2025-05-01T10:25:14.024" v="165" actId="1076"/>
          <ac:spMkLst>
            <pc:docMk/>
            <pc:sldMk cId="2203610160" sldId="272"/>
            <ac:spMk id="53" creationId="{49529816-E85F-D907-33F7-89C35F95FC40}"/>
          </ac:spMkLst>
        </pc:spChg>
        <pc:spChg chg="add mod">
          <ac:chgData name="Arber, Charlie" userId="a4408506-200b-48fd-8fce-b836ccf79d22" providerId="ADAL" clId="{4948E1E4-26F2-F34E-9E67-BE929835C6A7}" dt="2025-05-01T10:25:18.677" v="167" actId="1076"/>
          <ac:spMkLst>
            <pc:docMk/>
            <pc:sldMk cId="2203610160" sldId="272"/>
            <ac:spMk id="54" creationId="{A6C6861D-BBC5-6E91-E518-C3E8374EEF6C}"/>
          </ac:spMkLst>
        </pc:spChg>
        <pc:spChg chg="add mod">
          <ac:chgData name="Arber, Charlie" userId="a4408506-200b-48fd-8fce-b836ccf79d22" providerId="ADAL" clId="{4948E1E4-26F2-F34E-9E67-BE929835C6A7}" dt="2025-05-01T10:25:25.381" v="169" actId="1076"/>
          <ac:spMkLst>
            <pc:docMk/>
            <pc:sldMk cId="2203610160" sldId="272"/>
            <ac:spMk id="55" creationId="{C96ED0C3-4862-E42C-9B0E-9950FEBCB86C}"/>
          </ac:spMkLst>
        </pc:spChg>
        <pc:spChg chg="add mod">
          <ac:chgData name="Arber, Charlie" userId="a4408506-200b-48fd-8fce-b836ccf79d22" providerId="ADAL" clId="{4948E1E4-26F2-F34E-9E67-BE929835C6A7}" dt="2025-05-01T10:25:29.476" v="171" actId="1076"/>
          <ac:spMkLst>
            <pc:docMk/>
            <pc:sldMk cId="2203610160" sldId="272"/>
            <ac:spMk id="56" creationId="{C6EBE7E7-5C02-35D6-EBF6-909815B9E17E}"/>
          </ac:spMkLst>
        </pc:spChg>
        <pc:spChg chg="add mod">
          <ac:chgData name="Arber, Charlie" userId="a4408506-200b-48fd-8fce-b836ccf79d22" providerId="ADAL" clId="{4948E1E4-26F2-F34E-9E67-BE929835C6A7}" dt="2025-05-01T10:25:33.722" v="173" actId="1076"/>
          <ac:spMkLst>
            <pc:docMk/>
            <pc:sldMk cId="2203610160" sldId="272"/>
            <ac:spMk id="57" creationId="{C046DF20-7009-3950-B2C9-EED58D382DB9}"/>
          </ac:spMkLst>
        </pc:spChg>
        <pc:spChg chg="add mod">
          <ac:chgData name="Arber, Charlie" userId="a4408506-200b-48fd-8fce-b836ccf79d22" providerId="ADAL" clId="{4948E1E4-26F2-F34E-9E67-BE929835C6A7}" dt="2025-05-01T10:25:45.734" v="177" actId="1076"/>
          <ac:spMkLst>
            <pc:docMk/>
            <pc:sldMk cId="2203610160" sldId="272"/>
            <ac:spMk id="58" creationId="{9B7A989B-6AF1-8E46-845E-B24B6803ECCD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59" creationId="{D881617E-9026-FF54-06D4-E7203153CCFB}"/>
          </ac:spMkLst>
        </pc:spChg>
        <pc:spChg chg="add mod">
          <ac:chgData name="Arber, Charlie" userId="a4408506-200b-48fd-8fce-b836ccf79d22" providerId="ADAL" clId="{4948E1E4-26F2-F34E-9E67-BE929835C6A7}" dt="2025-05-01T10:29:14.643" v="272" actId="1035"/>
          <ac:spMkLst>
            <pc:docMk/>
            <pc:sldMk cId="2203610160" sldId="272"/>
            <ac:spMk id="60" creationId="{5372BE0B-6C64-18EC-D2DA-F8C7D001559D}"/>
          </ac:spMkLst>
        </pc:spChg>
        <pc:spChg chg="add mod">
          <ac:chgData name="Arber, Charlie" userId="a4408506-200b-48fd-8fce-b836ccf79d22" providerId="ADAL" clId="{4948E1E4-26F2-F34E-9E67-BE929835C6A7}" dt="2025-05-01T10:26:10.064" v="189" actId="1076"/>
          <ac:spMkLst>
            <pc:docMk/>
            <pc:sldMk cId="2203610160" sldId="272"/>
            <ac:spMk id="61" creationId="{8D4BE881-69C5-E5A1-D97D-3EBFAF76ECB1}"/>
          </ac:spMkLst>
        </pc:spChg>
        <pc:spChg chg="add mod">
          <ac:chgData name="Arber, Charlie" userId="a4408506-200b-48fd-8fce-b836ccf79d22" providerId="ADAL" clId="{4948E1E4-26F2-F34E-9E67-BE929835C6A7}" dt="2025-05-01T10:28:12.800" v="243" actId="207"/>
          <ac:spMkLst>
            <pc:docMk/>
            <pc:sldMk cId="2203610160" sldId="272"/>
            <ac:spMk id="62" creationId="{860432FC-DED0-DFA6-3FB4-B16F24B88C1E}"/>
          </ac:spMkLst>
        </pc:spChg>
        <pc:spChg chg="add mod">
          <ac:chgData name="Arber, Charlie" userId="a4408506-200b-48fd-8fce-b836ccf79d22" providerId="ADAL" clId="{4948E1E4-26F2-F34E-9E67-BE929835C6A7}" dt="2025-05-01T10:29:24.375" v="279" actId="1035"/>
          <ac:spMkLst>
            <pc:docMk/>
            <pc:sldMk cId="2203610160" sldId="272"/>
            <ac:spMk id="63" creationId="{E3A14D86-5505-E537-ED69-0CDD429875A0}"/>
          </ac:spMkLst>
        </pc:spChg>
        <pc:spChg chg="add mod">
          <ac:chgData name="Arber, Charlie" userId="a4408506-200b-48fd-8fce-b836ccf79d22" providerId="ADAL" clId="{4948E1E4-26F2-F34E-9E67-BE929835C6A7}" dt="2025-05-01T10:29:17.591" v="274" actId="1037"/>
          <ac:spMkLst>
            <pc:docMk/>
            <pc:sldMk cId="2203610160" sldId="272"/>
            <ac:spMk id="64" creationId="{DBA64E3D-FFD6-649C-4433-789F820C603B}"/>
          </ac:spMkLst>
        </pc:spChg>
        <pc:spChg chg="mod">
          <ac:chgData name="Arber, Charlie" userId="a4408506-200b-48fd-8fce-b836ccf79d22" providerId="ADAL" clId="{4948E1E4-26F2-F34E-9E67-BE929835C6A7}" dt="2025-05-19T09:18:56.964" v="454" actId="1036"/>
          <ac:spMkLst>
            <pc:docMk/>
            <pc:sldMk cId="2203610160" sldId="272"/>
            <ac:spMk id="65" creationId="{C5A57BBA-1127-7A11-3A91-ABC25315FB84}"/>
          </ac:spMkLst>
        </pc:spChg>
        <pc:picChg chg="mod modCrop">
          <ac:chgData name="Arber, Charlie" userId="a4408506-200b-48fd-8fce-b836ccf79d22" providerId="ADAL" clId="{4948E1E4-26F2-F34E-9E67-BE929835C6A7}" dt="2025-05-01T10:27:35.639" v="224" actId="732"/>
          <ac:picMkLst>
            <pc:docMk/>
            <pc:sldMk cId="2203610160" sldId="272"/>
            <ac:picMk id="3" creationId="{C2076198-3113-D311-6C7B-0BB11C4F0921}"/>
          </ac:picMkLst>
        </pc:picChg>
        <pc:cxnChg chg="mod">
          <ac:chgData name="Arber, Charlie" userId="a4408506-200b-48fd-8fce-b836ccf79d22" providerId="ADAL" clId="{4948E1E4-26F2-F34E-9E67-BE929835C6A7}" dt="2025-05-01T10:26:59.008" v="222" actId="1036"/>
          <ac:cxnSpMkLst>
            <pc:docMk/>
            <pc:sldMk cId="2203610160" sldId="272"/>
            <ac:cxnSpMk id="9" creationId="{F3AD3B27-40AA-4C6F-E272-C0AFB3782A56}"/>
          </ac:cxnSpMkLst>
        </pc:cxnChg>
      </pc:sldChg>
    </pc:docChg>
  </pc:docChgLst>
  <pc:docChgLst>
    <pc:chgData name="Arber, Charlie" userId="a4408506-200b-48fd-8fce-b836ccf79d22" providerId="ADAL" clId="{F6C84A86-9CD1-744E-A635-11D94D9C390E}"/>
    <pc:docChg chg="delSld modSld">
      <pc:chgData name="Arber, Charlie" userId="a4408506-200b-48fd-8fce-b836ccf79d22" providerId="ADAL" clId="{F6C84A86-9CD1-744E-A635-11D94D9C390E}" dt="2025-05-21T08:28:16.672" v="3" actId="20577"/>
      <pc:docMkLst>
        <pc:docMk/>
      </pc:docMkLst>
      <pc:sldChg chg="del">
        <pc:chgData name="Arber, Charlie" userId="a4408506-200b-48fd-8fce-b836ccf79d22" providerId="ADAL" clId="{F6C84A86-9CD1-744E-A635-11D94D9C390E}" dt="2025-05-21T08:00:33.794" v="1" actId="2696"/>
        <pc:sldMkLst>
          <pc:docMk/>
          <pc:sldMk cId="1824934342" sldId="259"/>
        </pc:sldMkLst>
      </pc:sldChg>
      <pc:sldChg chg="modSp mod">
        <pc:chgData name="Arber, Charlie" userId="a4408506-200b-48fd-8fce-b836ccf79d22" providerId="ADAL" clId="{F6C84A86-9CD1-744E-A635-11D94D9C390E}" dt="2025-05-21T08:28:16.672" v="3" actId="20577"/>
        <pc:sldMkLst>
          <pc:docMk/>
          <pc:sldMk cId="874222305" sldId="273"/>
        </pc:sldMkLst>
        <pc:spChg chg="mod">
          <ac:chgData name="Arber, Charlie" userId="a4408506-200b-48fd-8fce-b836ccf79d22" providerId="ADAL" clId="{F6C84A86-9CD1-744E-A635-11D94D9C390E}" dt="2025-05-21T08:28:16.672" v="3" actId="20577"/>
          <ac:spMkLst>
            <pc:docMk/>
            <pc:sldMk cId="874222305" sldId="273"/>
            <ac:spMk id="4" creationId="{91806858-BFA4-7A7F-29FE-F882B0548DD5}"/>
          </ac:spMkLst>
        </pc:spChg>
      </pc:sldChg>
      <pc:sldChg chg="del">
        <pc:chgData name="Arber, Charlie" userId="a4408506-200b-48fd-8fce-b836ccf79d22" providerId="ADAL" clId="{F6C84A86-9CD1-744E-A635-11D94D9C390E}" dt="2025-05-21T08:00:33.772" v="0" actId="2696"/>
        <pc:sldMkLst>
          <pc:docMk/>
          <pc:sldMk cId="2847703039" sldId="274"/>
        </pc:sldMkLst>
      </pc:sldChg>
    </pc:docChg>
  </pc:docChgLst>
  <pc:docChgLst>
    <pc:chgData name="Arber, Charlie" userId="a4408506-200b-48fd-8fce-b836ccf79d22" providerId="ADAL" clId="{78747762-8061-CC4D-85B7-B8E5DB41CAE9}"/>
    <pc:docChg chg="custSel modSld">
      <pc:chgData name="Arber, Charlie" userId="a4408506-200b-48fd-8fce-b836ccf79d22" providerId="ADAL" clId="{78747762-8061-CC4D-85B7-B8E5DB41CAE9}" dt="2025-05-20T16:03:44.360" v="387" actId="115"/>
      <pc:docMkLst>
        <pc:docMk/>
      </pc:docMkLst>
      <pc:sldChg chg="addSp modSp mod">
        <pc:chgData name="Arber, Charlie" userId="a4408506-200b-48fd-8fce-b836ccf79d22" providerId="ADAL" clId="{78747762-8061-CC4D-85B7-B8E5DB41CAE9}" dt="2025-05-05T09:29:34.334" v="49" actId="1076"/>
        <pc:sldMkLst>
          <pc:docMk/>
          <pc:sldMk cId="2550048449" sldId="261"/>
        </pc:sldMkLst>
        <pc:picChg chg="mod">
          <ac:chgData name="Arber, Charlie" userId="a4408506-200b-48fd-8fce-b836ccf79d22" providerId="ADAL" clId="{78747762-8061-CC4D-85B7-B8E5DB41CAE9}" dt="2025-05-05T09:27:29.472" v="34" actId="1076"/>
          <ac:picMkLst>
            <pc:docMk/>
            <pc:sldMk cId="2550048449" sldId="261"/>
            <ac:picMk id="6" creationId="{C3C30D00-30E6-AF80-BE3F-AD487E6B9545}"/>
          </ac:picMkLst>
        </pc:picChg>
        <pc:picChg chg="mod">
          <ac:chgData name="Arber, Charlie" userId="a4408506-200b-48fd-8fce-b836ccf79d22" providerId="ADAL" clId="{78747762-8061-CC4D-85B7-B8E5DB41CAE9}" dt="2025-05-05T09:27:29.472" v="34" actId="1076"/>
          <ac:picMkLst>
            <pc:docMk/>
            <pc:sldMk cId="2550048449" sldId="261"/>
            <ac:picMk id="7" creationId="{808FC227-766D-8814-6530-8C654572C555}"/>
          </ac:picMkLst>
        </pc:picChg>
        <pc:picChg chg="mod">
          <ac:chgData name="Arber, Charlie" userId="a4408506-200b-48fd-8fce-b836ccf79d22" providerId="ADAL" clId="{78747762-8061-CC4D-85B7-B8E5DB41CAE9}" dt="2025-05-05T09:27:29.472" v="34" actId="1076"/>
          <ac:picMkLst>
            <pc:docMk/>
            <pc:sldMk cId="2550048449" sldId="261"/>
            <ac:picMk id="8" creationId="{08ED6297-3B44-A13A-E5E0-2243F4625732}"/>
          </ac:picMkLst>
        </pc:picChg>
        <pc:picChg chg="add mod">
          <ac:chgData name="Arber, Charlie" userId="a4408506-200b-48fd-8fce-b836ccf79d22" providerId="ADAL" clId="{78747762-8061-CC4D-85B7-B8E5DB41CAE9}" dt="2025-05-05T09:29:34.334" v="49" actId="1076"/>
          <ac:picMkLst>
            <pc:docMk/>
            <pc:sldMk cId="2550048449" sldId="261"/>
            <ac:picMk id="14" creationId="{225976A4-04B0-C3C6-0885-211F0D3CE7B4}"/>
          </ac:picMkLst>
        </pc:picChg>
        <pc:picChg chg="add mod">
          <ac:chgData name="Arber, Charlie" userId="a4408506-200b-48fd-8fce-b836ccf79d22" providerId="ADAL" clId="{78747762-8061-CC4D-85B7-B8E5DB41CAE9}" dt="2025-05-05T09:29:32.578" v="48" actId="1076"/>
          <ac:picMkLst>
            <pc:docMk/>
            <pc:sldMk cId="2550048449" sldId="261"/>
            <ac:picMk id="15" creationId="{02F0F4E6-F3C7-079F-9E9F-A6DDFE7DCBDD}"/>
          </ac:picMkLst>
        </pc:picChg>
      </pc:sldChg>
      <pc:sldChg chg="addSp modSp mod">
        <pc:chgData name="Arber, Charlie" userId="a4408506-200b-48fd-8fce-b836ccf79d22" providerId="ADAL" clId="{78747762-8061-CC4D-85B7-B8E5DB41CAE9}" dt="2025-05-20T16:03:44.360" v="387" actId="115"/>
        <pc:sldMkLst>
          <pc:docMk/>
          <pc:sldMk cId="2203610160" sldId="272"/>
        </pc:sldMkLst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" creationId="{EC5E64B6-F9F4-39EE-A37A-7B64F91702A8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" creationId="{E3C40C47-0845-1F0D-D745-9439955F9C8B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7" creationId="{379D3050-084D-F763-8631-822FAC4EAB1B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10" creationId="{F09AE50E-765E-91A2-7E65-17EFA5552774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12" creationId="{B586BDE1-048F-422F-6A03-1726C22A039A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13" creationId="{368AD89E-2098-DAD5-1FC0-D481681EF6D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14" creationId="{F66DE50C-112D-5A12-5AD4-DAA260DF07F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15" creationId="{D4A761C0-38B0-53D2-99BF-C2FFF29F49BA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16" creationId="{7029036A-2E66-DB25-6B19-CCDE5337907B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17" creationId="{D0030794-1712-25E4-309D-77A948227946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18" creationId="{80920990-B928-EB4B-71BE-59BE28B8959D}"/>
          </ac:spMkLst>
        </pc:spChg>
        <pc:spChg chg="mod">
          <ac:chgData name="Arber, Charlie" userId="a4408506-200b-48fd-8fce-b836ccf79d22" providerId="ADAL" clId="{78747762-8061-CC4D-85B7-B8E5DB41CAE9}" dt="2025-05-18T14:00:46.058" v="167" actId="1035"/>
          <ac:spMkLst>
            <pc:docMk/>
            <pc:sldMk cId="2203610160" sldId="272"/>
            <ac:spMk id="19" creationId="{B6C8B99D-7EB0-EB3E-5196-3BEC1B13C319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0" creationId="{F4815F47-F539-20F3-736B-8906A582F416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1" creationId="{7DE6331D-7B9E-4C23-A086-A01AC16AF509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2" creationId="{50ED8F49-A18E-857F-7371-8120B717BBB1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3" creationId="{FE276D1F-1847-7739-22DC-7373A36FEFC1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4" creationId="{43107D48-F57D-B422-28E7-3AB45A5B3948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5" creationId="{D8B20E97-5675-1E72-159B-E504B16878A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6" creationId="{F439D488-F2DB-D497-1256-D243961056E6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7" creationId="{3766C41A-CE32-C4D1-714A-875E981FF2EA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8" creationId="{31134BBE-D749-E0E3-7E84-F31D363A225C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29" creationId="{60F0E33C-990A-BB0E-0A2E-91A217E893DF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0" creationId="{06DE5E85-80F2-99CA-1243-00C4EAF67F23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1" creationId="{4E3AE2BB-FAF1-CDCC-87A7-954AC8042162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2" creationId="{8738369F-AC95-9FBA-4E7F-DFE378639742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3" creationId="{4CD7EBE7-4325-A278-3B6A-E956A44C0D5E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4" creationId="{8C9BAB3B-F627-0A4D-966F-1012573A7FA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5" creationId="{53D3D7A3-0004-B934-2C52-82B0EFD82EC3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6" creationId="{A2D802D9-B1C2-71A2-7B6A-94ED50EBA0C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7" creationId="{DC1E8F12-2C44-12D5-A34F-1FE437A8B4DB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8" creationId="{73C71215-84FC-63AC-1841-4C7D43F66DAB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39" creationId="{9B7CB8F8-EDB2-5532-7CE3-E4165C5259AF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0" creationId="{1C4EE0A9-F6EA-0F2A-E5D9-43185BE94B81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1" creationId="{11387D3B-CC2D-F1F6-3F47-E21D52FC1D9A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2" creationId="{E3B8701F-64FB-BB1A-F791-51683BFF2DC3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3" creationId="{A7E7D719-2F08-584B-4EFF-A6D40BDF46FE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4" creationId="{48B3EFD6-482C-D842-4FF0-F82DC00A74D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5" creationId="{F02EA13F-6E63-9090-11B9-055BEE1F17BB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6" creationId="{99E51061-C73C-BB7A-BA3F-6D6EC9589FDC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7" creationId="{294BEF16-7D82-A4D0-F6FB-BFE97B24216E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8" creationId="{84852571-D8C9-63EF-A9D6-C7B808E2B358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49" creationId="{11D55465-CE25-778C-4B12-46527C5B27C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0" creationId="{4FA4C768-293D-B935-B1F7-51DA8359A0CC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1" creationId="{745CE393-3796-1A6B-B318-3EF4B49FF415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2" creationId="{A382EDBA-F6A6-40C5-6735-1CFDC388724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3" creationId="{49529816-E85F-D907-33F7-89C35F95FC4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4" creationId="{A6C6861D-BBC5-6E91-E518-C3E8374EEF6C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5" creationId="{C96ED0C3-4862-E42C-9B0E-9950FEBCB86C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6" creationId="{C6EBE7E7-5C02-35D6-EBF6-909815B9E17E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7" creationId="{C046DF20-7009-3950-B2C9-EED58D382DB9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8" creationId="{9B7A989B-6AF1-8E46-845E-B24B6803ECC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59" creationId="{D881617E-9026-FF54-06D4-E7203153CCFB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60" creationId="{5372BE0B-6C64-18EC-D2DA-F8C7D001559D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61" creationId="{8D4BE881-69C5-E5A1-D97D-3EBFAF76ECB1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62" creationId="{860432FC-DED0-DFA6-3FB4-B16F24B88C1E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63" creationId="{E3A14D86-5505-E537-ED69-0CDD429875A0}"/>
          </ac:spMkLst>
        </pc:spChg>
        <pc:spChg chg="mod">
          <ac:chgData name="Arber, Charlie" userId="a4408506-200b-48fd-8fce-b836ccf79d22" providerId="ADAL" clId="{78747762-8061-CC4D-85B7-B8E5DB41CAE9}" dt="2025-05-20T16:03:29.844" v="385" actId="1035"/>
          <ac:spMkLst>
            <pc:docMk/>
            <pc:sldMk cId="2203610160" sldId="272"/>
            <ac:spMk id="64" creationId="{DBA64E3D-FFD6-649C-4433-789F820C603B}"/>
          </ac:spMkLst>
        </pc:spChg>
        <pc:spChg chg="add mod">
          <ac:chgData name="Arber, Charlie" userId="a4408506-200b-48fd-8fce-b836ccf79d22" providerId="ADAL" clId="{78747762-8061-CC4D-85B7-B8E5DB41CAE9}" dt="2025-05-20T16:03:44.360" v="387" actId="115"/>
          <ac:spMkLst>
            <pc:docMk/>
            <pc:sldMk cId="2203610160" sldId="272"/>
            <ac:spMk id="65" creationId="{C5A57BBA-1127-7A11-3A91-ABC25315FB84}"/>
          </ac:spMkLst>
        </pc:spChg>
        <pc:picChg chg="mod">
          <ac:chgData name="Arber, Charlie" userId="a4408506-200b-48fd-8fce-b836ccf79d22" providerId="ADAL" clId="{78747762-8061-CC4D-85B7-B8E5DB41CAE9}" dt="2025-05-20T16:03:29.844" v="385" actId="1035"/>
          <ac:picMkLst>
            <pc:docMk/>
            <pc:sldMk cId="2203610160" sldId="272"/>
            <ac:picMk id="3" creationId="{C2076198-3113-D311-6C7B-0BB11C4F0921}"/>
          </ac:picMkLst>
        </pc:picChg>
        <pc:picChg chg="mod">
          <ac:chgData name="Arber, Charlie" userId="a4408506-200b-48fd-8fce-b836ccf79d22" providerId="ADAL" clId="{78747762-8061-CC4D-85B7-B8E5DB41CAE9}" dt="2025-05-18T14:00:46.058" v="167" actId="1035"/>
          <ac:picMkLst>
            <pc:docMk/>
            <pc:sldMk cId="2203610160" sldId="272"/>
            <ac:picMk id="6" creationId="{2ED5D29E-6385-733E-4213-F995D0F26AF6}"/>
          </ac:picMkLst>
        </pc:picChg>
        <pc:picChg chg="mod">
          <ac:chgData name="Arber, Charlie" userId="a4408506-200b-48fd-8fce-b836ccf79d22" providerId="ADAL" clId="{78747762-8061-CC4D-85B7-B8E5DB41CAE9}" dt="2025-05-18T14:00:46.058" v="167" actId="1035"/>
          <ac:picMkLst>
            <pc:docMk/>
            <pc:sldMk cId="2203610160" sldId="272"/>
            <ac:picMk id="8" creationId="{F8226B8F-C2DA-B12C-F7FB-CFF424870617}"/>
          </ac:picMkLst>
        </pc:picChg>
        <pc:picChg chg="mod">
          <ac:chgData name="Arber, Charlie" userId="a4408506-200b-48fd-8fce-b836ccf79d22" providerId="ADAL" clId="{78747762-8061-CC4D-85B7-B8E5DB41CAE9}" dt="2025-05-18T14:00:46.058" v="167" actId="1035"/>
          <ac:picMkLst>
            <pc:docMk/>
            <pc:sldMk cId="2203610160" sldId="272"/>
            <ac:picMk id="11" creationId="{91D8AD32-6B4F-2817-D6B1-9A4C11B2D6C9}"/>
          </ac:picMkLst>
        </pc:picChg>
        <pc:cxnChg chg="mod">
          <ac:chgData name="Arber, Charlie" userId="a4408506-200b-48fd-8fce-b836ccf79d22" providerId="ADAL" clId="{78747762-8061-CC4D-85B7-B8E5DB41CAE9}" dt="2025-05-20T16:03:29.844" v="385" actId="1035"/>
          <ac:cxnSpMkLst>
            <pc:docMk/>
            <pc:sldMk cId="2203610160" sldId="272"/>
            <ac:cxnSpMk id="9" creationId="{F3AD3B27-40AA-4C6F-E272-C0AFB3782A56}"/>
          </ac:cxnSpMkLst>
        </pc:cxnChg>
      </pc:sldChg>
      <pc:sldChg chg="addSp modSp mod">
        <pc:chgData name="Arber, Charlie" userId="a4408506-200b-48fd-8fce-b836ccf79d22" providerId="ADAL" clId="{78747762-8061-CC4D-85B7-B8E5DB41CAE9}" dt="2025-04-16T06:34:02.833" v="33" actId="20577"/>
        <pc:sldMkLst>
          <pc:docMk/>
          <pc:sldMk cId="874222305" sldId="273"/>
        </pc:sldMkLst>
        <pc:spChg chg="add mod">
          <ac:chgData name="Arber, Charlie" userId="a4408506-200b-48fd-8fce-b836ccf79d22" providerId="ADAL" clId="{78747762-8061-CC4D-85B7-B8E5DB41CAE9}" dt="2025-04-16T06:34:02.833" v="33" actId="20577"/>
          <ac:spMkLst>
            <pc:docMk/>
            <pc:sldMk cId="874222305" sldId="273"/>
            <ac:spMk id="6" creationId="{91493164-F67C-BB20-9DA0-91A5FBCFE39D}"/>
          </ac:spMkLst>
        </pc:spChg>
        <pc:spChg chg="add mod">
          <ac:chgData name="Arber, Charlie" userId="a4408506-200b-48fd-8fce-b836ccf79d22" providerId="ADAL" clId="{78747762-8061-CC4D-85B7-B8E5DB41CAE9}" dt="2025-04-16T06:33:56.153" v="31" actId="14100"/>
          <ac:spMkLst>
            <pc:docMk/>
            <pc:sldMk cId="874222305" sldId="273"/>
            <ac:spMk id="8" creationId="{75F0C6D7-151F-C038-1C7A-EF1CD270CEDB}"/>
          </ac:spMkLst>
        </pc:spChg>
        <pc:picChg chg="add mod modCrop">
          <ac:chgData name="Arber, Charlie" userId="a4408506-200b-48fd-8fce-b836ccf79d22" providerId="ADAL" clId="{78747762-8061-CC4D-85B7-B8E5DB41CAE9}" dt="2025-04-16T06:31:49.099" v="8" actId="1076"/>
          <ac:picMkLst>
            <pc:docMk/>
            <pc:sldMk cId="874222305" sldId="273"/>
            <ac:picMk id="3" creationId="{1D7F4FA2-A536-F615-A3D5-7209F28F641A}"/>
          </ac:picMkLst>
        </pc:picChg>
      </pc:sldChg>
    </pc:docChg>
  </pc:docChgLst>
  <pc:docChgLst>
    <pc:chgData name="Arber, Charlie" userId="a4408506-200b-48fd-8fce-b836ccf79d22" providerId="ADAL" clId="{FCB01B69-BA5B-D242-B0D8-8BC9EBC732BB}"/>
    <pc:docChg chg="undo custSel modSld">
      <pc:chgData name="Arber, Charlie" userId="a4408506-200b-48fd-8fce-b836ccf79d22" providerId="ADAL" clId="{FCB01B69-BA5B-D242-B0D8-8BC9EBC732BB}" dt="2025-02-28T16:21:22.015" v="138" actId="14100"/>
      <pc:docMkLst>
        <pc:docMk/>
      </pc:docMkLst>
      <pc:sldChg chg="addSp delSp modSp mod">
        <pc:chgData name="Arber, Charlie" userId="a4408506-200b-48fd-8fce-b836ccf79d22" providerId="ADAL" clId="{FCB01B69-BA5B-D242-B0D8-8BC9EBC732BB}" dt="2025-02-28T16:21:22.015" v="138" actId="14100"/>
        <pc:sldMkLst>
          <pc:docMk/>
          <pc:sldMk cId="1088065246" sldId="266"/>
        </pc:sldMkLst>
        <pc:spChg chg="mod">
          <ac:chgData name="Arber, Charlie" userId="a4408506-200b-48fd-8fce-b836ccf79d22" providerId="ADAL" clId="{FCB01B69-BA5B-D242-B0D8-8BC9EBC732BB}" dt="2025-02-20T13:56:26.782" v="26" actId="1036"/>
          <ac:spMkLst>
            <pc:docMk/>
            <pc:sldMk cId="1088065246" sldId="266"/>
            <ac:spMk id="9" creationId="{FF03C5FE-7688-D0B9-99B6-DEE8025B3669}"/>
          </ac:spMkLst>
        </pc:spChg>
        <pc:spChg chg="mod">
          <ac:chgData name="Arber, Charlie" userId="a4408506-200b-48fd-8fce-b836ccf79d22" providerId="ADAL" clId="{FCB01B69-BA5B-D242-B0D8-8BC9EBC732BB}" dt="2025-02-20T13:56:26.782" v="26" actId="1036"/>
          <ac:spMkLst>
            <pc:docMk/>
            <pc:sldMk cId="1088065246" sldId="266"/>
            <ac:spMk id="10" creationId="{86D37FC7-4D6B-D7A5-8501-C020ADF8F67E}"/>
          </ac:spMkLst>
        </pc:spChg>
        <pc:spChg chg="mod">
          <ac:chgData name="Arber, Charlie" userId="a4408506-200b-48fd-8fce-b836ccf79d22" providerId="ADAL" clId="{FCB01B69-BA5B-D242-B0D8-8BC9EBC732BB}" dt="2025-02-20T13:57:45.651" v="81" actId="1036"/>
          <ac:spMkLst>
            <pc:docMk/>
            <pc:sldMk cId="1088065246" sldId="266"/>
            <ac:spMk id="13" creationId="{50740DFC-28AC-408B-C3A7-E1EE8F818B12}"/>
          </ac:spMkLst>
        </pc:spChg>
        <pc:spChg chg="mod">
          <ac:chgData name="Arber, Charlie" userId="a4408506-200b-48fd-8fce-b836ccf79d22" providerId="ADAL" clId="{FCB01B69-BA5B-D242-B0D8-8BC9EBC732BB}" dt="2025-02-20T13:57:45.651" v="81" actId="1036"/>
          <ac:spMkLst>
            <pc:docMk/>
            <pc:sldMk cId="1088065246" sldId="266"/>
            <ac:spMk id="26" creationId="{7F6B1895-2A5C-D50E-AC7B-1D59322AC378}"/>
          </ac:spMkLst>
        </pc:spChg>
        <pc:spChg chg="mod">
          <ac:chgData name="Arber, Charlie" userId="a4408506-200b-48fd-8fce-b836ccf79d22" providerId="ADAL" clId="{FCB01B69-BA5B-D242-B0D8-8BC9EBC732BB}" dt="2025-02-20T13:56:26.782" v="26" actId="1036"/>
          <ac:spMkLst>
            <pc:docMk/>
            <pc:sldMk cId="1088065246" sldId="266"/>
            <ac:spMk id="27" creationId="{76207F96-9C8B-9D85-31F7-F667D3139598}"/>
          </ac:spMkLst>
        </pc:spChg>
        <pc:spChg chg="mod">
          <ac:chgData name="Arber, Charlie" userId="a4408506-200b-48fd-8fce-b836ccf79d22" providerId="ADAL" clId="{FCB01B69-BA5B-D242-B0D8-8BC9EBC732BB}" dt="2025-02-20T13:56:26.782" v="26" actId="1036"/>
          <ac:spMkLst>
            <pc:docMk/>
            <pc:sldMk cId="1088065246" sldId="266"/>
            <ac:spMk id="28" creationId="{0F3DD3B1-4349-F699-46A2-691E0644AC7B}"/>
          </ac:spMkLst>
        </pc:spChg>
        <pc:spChg chg="mod">
          <ac:chgData name="Arber, Charlie" userId="a4408506-200b-48fd-8fce-b836ccf79d22" providerId="ADAL" clId="{FCB01B69-BA5B-D242-B0D8-8BC9EBC732BB}" dt="2025-02-20T14:56:46.885" v="126" actId="1076"/>
          <ac:spMkLst>
            <pc:docMk/>
            <pc:sldMk cId="1088065246" sldId="266"/>
            <ac:spMk id="51" creationId="{4CA72D3F-B4A8-E1D9-68BA-BED268CA9CEF}"/>
          </ac:spMkLst>
        </pc:spChg>
        <pc:spChg chg="mod">
          <ac:chgData name="Arber, Charlie" userId="a4408506-200b-48fd-8fce-b836ccf79d22" providerId="ADAL" clId="{FCB01B69-BA5B-D242-B0D8-8BC9EBC732BB}" dt="2025-02-20T14:56:54.593" v="127" actId="1076"/>
          <ac:spMkLst>
            <pc:docMk/>
            <pc:sldMk cId="1088065246" sldId="266"/>
            <ac:spMk id="55" creationId="{B8E22B62-14C0-5841-2F9E-4FF078A9CFBA}"/>
          </ac:spMkLst>
        </pc:spChg>
        <pc:spChg chg="mod">
          <ac:chgData name="Arber, Charlie" userId="a4408506-200b-48fd-8fce-b836ccf79d22" providerId="ADAL" clId="{FCB01B69-BA5B-D242-B0D8-8BC9EBC732BB}" dt="2025-02-20T14:56:58.789" v="128" actId="1076"/>
          <ac:spMkLst>
            <pc:docMk/>
            <pc:sldMk cId="1088065246" sldId="266"/>
            <ac:spMk id="56" creationId="{32B94965-EC55-045C-8353-EF069DC5B2D8}"/>
          </ac:spMkLst>
        </pc:spChg>
        <pc:spChg chg="add mod">
          <ac:chgData name="Arber, Charlie" userId="a4408506-200b-48fd-8fce-b836ccf79d22" providerId="ADAL" clId="{FCB01B69-BA5B-D242-B0D8-8BC9EBC732BB}" dt="2025-02-20T13:57:30.599" v="76" actId="1035"/>
          <ac:spMkLst>
            <pc:docMk/>
            <pc:sldMk cId="1088065246" sldId="266"/>
            <ac:spMk id="57" creationId="{3BB1F02C-4D72-EEA5-0A6F-33F466222F79}"/>
          </ac:spMkLst>
        </pc:spChg>
        <pc:spChg chg="add mod">
          <ac:chgData name="Arber, Charlie" userId="a4408506-200b-48fd-8fce-b836ccf79d22" providerId="ADAL" clId="{FCB01B69-BA5B-D242-B0D8-8BC9EBC732BB}" dt="2025-02-20T13:57:30.599" v="76" actId="1035"/>
          <ac:spMkLst>
            <pc:docMk/>
            <pc:sldMk cId="1088065246" sldId="266"/>
            <ac:spMk id="59" creationId="{5C80D0F8-7AC7-C5F2-3763-9A2189BDA0E2}"/>
          </ac:spMkLst>
        </pc:spChg>
        <pc:picChg chg="add mod">
          <ac:chgData name="Arber, Charlie" userId="a4408506-200b-48fd-8fce-b836ccf79d22" providerId="ADAL" clId="{FCB01B69-BA5B-D242-B0D8-8BC9EBC732BB}" dt="2025-02-20T13:57:30.599" v="76" actId="1035"/>
          <ac:picMkLst>
            <pc:docMk/>
            <pc:sldMk cId="1088065246" sldId="266"/>
            <ac:picMk id="2" creationId="{9F641774-2AD0-FF1C-2948-8F44C8AFD20B}"/>
          </ac:picMkLst>
        </pc:picChg>
        <pc:picChg chg="add mod">
          <ac:chgData name="Arber, Charlie" userId="a4408506-200b-48fd-8fce-b836ccf79d22" providerId="ADAL" clId="{FCB01B69-BA5B-D242-B0D8-8BC9EBC732BB}" dt="2025-02-28T16:21:09.586" v="135" actId="208"/>
          <ac:picMkLst>
            <pc:docMk/>
            <pc:sldMk cId="1088065246" sldId="266"/>
            <ac:picMk id="4" creationId="{DAFD48C1-6060-836C-C40A-66A54F1A9900}"/>
          </ac:picMkLst>
        </pc:picChg>
        <pc:picChg chg="mod">
          <ac:chgData name="Arber, Charlie" userId="a4408506-200b-48fd-8fce-b836ccf79d22" providerId="ADAL" clId="{FCB01B69-BA5B-D242-B0D8-8BC9EBC732BB}" dt="2025-02-20T13:56:26.782" v="26" actId="1036"/>
          <ac:picMkLst>
            <pc:docMk/>
            <pc:sldMk cId="1088065246" sldId="266"/>
            <ac:picMk id="6" creationId="{B9F717E8-8B4B-B4F4-D8EF-3E164EEEABAE}"/>
          </ac:picMkLst>
        </pc:picChg>
        <pc:picChg chg="mod">
          <ac:chgData name="Arber, Charlie" userId="a4408506-200b-48fd-8fce-b836ccf79d22" providerId="ADAL" clId="{FCB01B69-BA5B-D242-B0D8-8BC9EBC732BB}" dt="2025-02-20T13:56:26.782" v="26" actId="1036"/>
          <ac:picMkLst>
            <pc:docMk/>
            <pc:sldMk cId="1088065246" sldId="266"/>
            <ac:picMk id="8" creationId="{29A7BDC1-4E93-ACE4-00D0-BC69FBCBC8EA}"/>
          </ac:picMkLst>
        </pc:picChg>
        <pc:picChg chg="mod">
          <ac:chgData name="Arber, Charlie" userId="a4408506-200b-48fd-8fce-b836ccf79d22" providerId="ADAL" clId="{FCB01B69-BA5B-D242-B0D8-8BC9EBC732BB}" dt="2025-02-20T13:57:45.651" v="81" actId="1036"/>
          <ac:picMkLst>
            <pc:docMk/>
            <pc:sldMk cId="1088065246" sldId="266"/>
            <ac:picMk id="12" creationId="{57E629DC-9472-4521-BF7A-63DE0CC0AD24}"/>
          </ac:picMkLst>
        </pc:picChg>
        <pc:picChg chg="add mod">
          <ac:chgData name="Arber, Charlie" userId="a4408506-200b-48fd-8fce-b836ccf79d22" providerId="ADAL" clId="{FCB01B69-BA5B-D242-B0D8-8BC9EBC732BB}" dt="2025-02-20T14:55:55.329" v="123" actId="14100"/>
          <ac:picMkLst>
            <pc:docMk/>
            <pc:sldMk cId="1088065246" sldId="266"/>
            <ac:picMk id="63" creationId="{149CB310-6D9F-1096-1546-F2084D1B784E}"/>
          </ac:picMkLst>
        </pc:picChg>
        <pc:picChg chg="add mod">
          <ac:chgData name="Arber, Charlie" userId="a4408506-200b-48fd-8fce-b836ccf79d22" providerId="ADAL" clId="{FCB01B69-BA5B-D242-B0D8-8BC9EBC732BB}" dt="2025-02-20T14:56:20.333" v="124" actId="14100"/>
          <ac:picMkLst>
            <pc:docMk/>
            <pc:sldMk cId="1088065246" sldId="266"/>
            <ac:picMk id="64" creationId="{0CF7A283-D4C2-E7C7-8A05-EF65D167F6E5}"/>
          </ac:picMkLst>
        </pc:picChg>
        <pc:picChg chg="add mod">
          <ac:chgData name="Arber, Charlie" userId="a4408506-200b-48fd-8fce-b836ccf79d22" providerId="ADAL" clId="{FCB01B69-BA5B-D242-B0D8-8BC9EBC732BB}" dt="2025-02-20T14:56:24.973" v="125" actId="14100"/>
          <ac:picMkLst>
            <pc:docMk/>
            <pc:sldMk cId="1088065246" sldId="266"/>
            <ac:picMk id="65" creationId="{ACA8774D-7A54-0431-9265-82F46A12D3E2}"/>
          </ac:picMkLst>
        </pc:picChg>
        <pc:cxnChg chg="mod">
          <ac:chgData name="Arber, Charlie" userId="a4408506-200b-48fd-8fce-b836ccf79d22" providerId="ADAL" clId="{FCB01B69-BA5B-D242-B0D8-8BC9EBC732BB}" dt="2025-02-20T13:57:30.599" v="76" actId="1035"/>
          <ac:cxnSpMkLst>
            <pc:docMk/>
            <pc:sldMk cId="1088065246" sldId="266"/>
            <ac:cxnSpMk id="19" creationId="{33E50E4D-FF9B-D09B-B903-6B35BED65CB5}"/>
          </ac:cxnSpMkLst>
        </pc:cxnChg>
        <pc:cxnChg chg="mod">
          <ac:chgData name="Arber, Charlie" userId="a4408506-200b-48fd-8fce-b836ccf79d22" providerId="ADAL" clId="{FCB01B69-BA5B-D242-B0D8-8BC9EBC732BB}" dt="2025-02-20T13:57:30.599" v="76" actId="1035"/>
          <ac:cxnSpMkLst>
            <pc:docMk/>
            <pc:sldMk cId="1088065246" sldId="266"/>
            <ac:cxnSpMk id="20" creationId="{DCF9CEEF-9703-F9D3-1F2C-9D1F2297B812}"/>
          </ac:cxnSpMkLst>
        </pc:cxnChg>
        <pc:cxnChg chg="mod">
          <ac:chgData name="Arber, Charlie" userId="a4408506-200b-48fd-8fce-b836ccf79d22" providerId="ADAL" clId="{FCB01B69-BA5B-D242-B0D8-8BC9EBC732BB}" dt="2025-02-20T13:57:30.599" v="76" actId="1035"/>
          <ac:cxnSpMkLst>
            <pc:docMk/>
            <pc:sldMk cId="1088065246" sldId="266"/>
            <ac:cxnSpMk id="21" creationId="{A1FA4039-EC2B-4292-2E58-1C11B617335C}"/>
          </ac:cxnSpMkLst>
        </pc:cxnChg>
        <pc:cxnChg chg="mod">
          <ac:chgData name="Arber, Charlie" userId="a4408506-200b-48fd-8fce-b836ccf79d22" providerId="ADAL" clId="{FCB01B69-BA5B-D242-B0D8-8BC9EBC732BB}" dt="2025-02-20T13:57:30.599" v="76" actId="1035"/>
          <ac:cxnSpMkLst>
            <pc:docMk/>
            <pc:sldMk cId="1088065246" sldId="266"/>
            <ac:cxnSpMk id="22" creationId="{B6EB6F04-977E-3FE3-8F1F-34ADDA4D5E59}"/>
          </ac:cxnSpMkLst>
        </pc:cxnChg>
        <pc:cxnChg chg="mod">
          <ac:chgData name="Arber, Charlie" userId="a4408506-200b-48fd-8fce-b836ccf79d22" providerId="ADAL" clId="{FCB01B69-BA5B-D242-B0D8-8BC9EBC732BB}" dt="2025-02-20T13:57:45.651" v="81" actId="1036"/>
          <ac:cxnSpMkLst>
            <pc:docMk/>
            <pc:sldMk cId="1088065246" sldId="266"/>
            <ac:cxnSpMk id="32" creationId="{8B635499-D611-5481-4197-6E6F29F5BB4C}"/>
          </ac:cxnSpMkLst>
        </pc:cxnChg>
        <pc:cxnChg chg="mod">
          <ac:chgData name="Arber, Charlie" userId="a4408506-200b-48fd-8fce-b836ccf79d22" providerId="ADAL" clId="{FCB01B69-BA5B-D242-B0D8-8BC9EBC732BB}" dt="2025-02-20T13:56:26.782" v="26" actId="1036"/>
          <ac:cxnSpMkLst>
            <pc:docMk/>
            <pc:sldMk cId="1088065246" sldId="266"/>
            <ac:cxnSpMk id="33" creationId="{9CAC4CEA-0D41-BD12-106D-63226BF9F801}"/>
          </ac:cxnSpMkLst>
        </pc:cxnChg>
        <pc:cxnChg chg="mod">
          <ac:chgData name="Arber, Charlie" userId="a4408506-200b-48fd-8fce-b836ccf79d22" providerId="ADAL" clId="{FCB01B69-BA5B-D242-B0D8-8BC9EBC732BB}" dt="2025-02-20T13:56:26.782" v="26" actId="1036"/>
          <ac:cxnSpMkLst>
            <pc:docMk/>
            <pc:sldMk cId="1088065246" sldId="266"/>
            <ac:cxnSpMk id="34" creationId="{596FD6F2-C375-F83B-A7CD-1DCC5F6B5C5C}"/>
          </ac:cxnSpMkLst>
        </pc:cxnChg>
        <pc:cxnChg chg="add mod">
          <ac:chgData name="Arber, Charlie" userId="a4408506-200b-48fd-8fce-b836ccf79d22" providerId="ADAL" clId="{FCB01B69-BA5B-D242-B0D8-8BC9EBC732BB}" dt="2025-02-20T13:57:30.599" v="76" actId="1035"/>
          <ac:cxnSpMkLst>
            <pc:docMk/>
            <pc:sldMk cId="1088065246" sldId="266"/>
            <ac:cxnSpMk id="58" creationId="{00048ADB-8810-6DD7-233D-3E3AB9A579BE}"/>
          </ac:cxnSpMkLst>
        </pc:cxnChg>
      </pc:sldChg>
    </pc:docChg>
  </pc:docChgLst>
  <pc:docChgLst>
    <pc:chgData name="Arber, Charlie" userId="a4408506-200b-48fd-8fce-b836ccf79d22" providerId="ADAL" clId="{53086ABA-F489-E945-B22E-825D7E911253}"/>
    <pc:docChg chg="undo custSel addSld delSld modSld">
      <pc:chgData name="Arber, Charlie" userId="a4408506-200b-48fd-8fce-b836ccf79d22" providerId="ADAL" clId="{53086ABA-F489-E945-B22E-825D7E911253}" dt="2025-04-14T11:07:55.783" v="119" actId="1037"/>
      <pc:docMkLst>
        <pc:docMk/>
      </pc:docMkLst>
      <pc:sldChg chg="add">
        <pc:chgData name="Arber, Charlie" userId="a4408506-200b-48fd-8fce-b836ccf79d22" providerId="ADAL" clId="{53086ABA-F489-E945-B22E-825D7E911253}" dt="2025-04-14T10:57:43.746" v="71"/>
        <pc:sldMkLst>
          <pc:docMk/>
          <pc:sldMk cId="1824934342" sldId="259"/>
        </pc:sldMkLst>
      </pc:sldChg>
      <pc:sldChg chg="addSp delSp modSp mod">
        <pc:chgData name="Arber, Charlie" userId="a4408506-200b-48fd-8fce-b836ccf79d22" providerId="ADAL" clId="{53086ABA-F489-E945-B22E-825D7E911253}" dt="2025-04-14T11:07:55.783" v="119" actId="1037"/>
        <pc:sldMkLst>
          <pc:docMk/>
          <pc:sldMk cId="1088065246" sldId="266"/>
        </pc:sldMkLst>
        <pc:spChg chg="add mod">
          <ac:chgData name="Arber, Charlie" userId="a4408506-200b-48fd-8fce-b836ccf79d22" providerId="ADAL" clId="{53086ABA-F489-E945-B22E-825D7E911253}" dt="2025-04-14T11:07:55.783" v="119" actId="1037"/>
          <ac:spMkLst>
            <pc:docMk/>
            <pc:sldMk cId="1088065246" sldId="266"/>
            <ac:spMk id="25" creationId="{310EA6EB-A8B6-509C-F5F0-B7EDAE699CFD}"/>
          </ac:spMkLst>
        </pc:spChg>
        <pc:picChg chg="mod">
          <ac:chgData name="Arber, Charlie" userId="a4408506-200b-48fd-8fce-b836ccf79d22" providerId="ADAL" clId="{53086ABA-F489-E945-B22E-825D7E911253}" dt="2025-04-14T11:04:50.916" v="108" actId="1076"/>
          <ac:picMkLst>
            <pc:docMk/>
            <pc:sldMk cId="1088065246" sldId="266"/>
            <ac:picMk id="4" creationId="{DAFD48C1-6060-836C-C40A-66A54F1A9900}"/>
          </ac:picMkLst>
        </pc:picChg>
      </pc:sldChg>
      <pc:sldChg chg="addSp modSp mod">
        <pc:chgData name="Arber, Charlie" userId="a4408506-200b-48fd-8fce-b836ccf79d22" providerId="ADAL" clId="{53086ABA-F489-E945-B22E-825D7E911253}" dt="2025-04-14T11:03:11.343" v="101" actId="1038"/>
        <pc:sldMkLst>
          <pc:docMk/>
          <pc:sldMk cId="2203610160" sldId="272"/>
        </pc:sldMkLst>
        <pc:spChg chg="mod">
          <ac:chgData name="Arber, Charlie" userId="a4408506-200b-48fd-8fce-b836ccf79d22" providerId="ADAL" clId="{53086ABA-F489-E945-B22E-825D7E911253}" dt="2025-04-11T16:10:19.631" v="67" actId="1038"/>
          <ac:spMkLst>
            <pc:docMk/>
            <pc:sldMk cId="2203610160" sldId="272"/>
            <ac:spMk id="7" creationId="{379D3050-084D-F763-8631-822FAC4EAB1B}"/>
          </ac:spMkLst>
        </pc:spChg>
        <pc:spChg chg="mod">
          <ac:chgData name="Arber, Charlie" userId="a4408506-200b-48fd-8fce-b836ccf79d22" providerId="ADAL" clId="{53086ABA-F489-E945-B22E-825D7E911253}" dt="2025-04-11T16:10:19.631" v="67" actId="1038"/>
          <ac:spMkLst>
            <pc:docMk/>
            <pc:sldMk cId="2203610160" sldId="272"/>
            <ac:spMk id="12" creationId="{B586BDE1-048F-422F-6A03-1726C22A039A}"/>
          </ac:spMkLst>
        </pc:spChg>
        <pc:spChg chg="mod">
          <ac:chgData name="Arber, Charlie" userId="a4408506-200b-48fd-8fce-b836ccf79d22" providerId="ADAL" clId="{53086ABA-F489-E945-B22E-825D7E911253}" dt="2025-04-11T16:10:19.631" v="67" actId="1038"/>
          <ac:spMkLst>
            <pc:docMk/>
            <pc:sldMk cId="2203610160" sldId="272"/>
            <ac:spMk id="13" creationId="{368AD89E-2098-DAD5-1FC0-D481681EF6DD}"/>
          </ac:spMkLst>
        </pc:spChg>
        <pc:spChg chg="add mod">
          <ac:chgData name="Arber, Charlie" userId="a4408506-200b-48fd-8fce-b836ccf79d22" providerId="ADAL" clId="{53086ABA-F489-E945-B22E-825D7E911253}" dt="2025-04-11T16:10:19.631" v="67" actId="1038"/>
          <ac:spMkLst>
            <pc:docMk/>
            <pc:sldMk cId="2203610160" sldId="272"/>
            <ac:spMk id="15" creationId="{D4A761C0-38B0-53D2-99BF-C2FFF29F49BA}"/>
          </ac:spMkLst>
        </pc:spChg>
        <pc:spChg chg="add mod">
          <ac:chgData name="Arber, Charlie" userId="a4408506-200b-48fd-8fce-b836ccf79d22" providerId="ADAL" clId="{53086ABA-F489-E945-B22E-825D7E911253}" dt="2025-04-14T11:02:35.117" v="74" actId="20577"/>
          <ac:spMkLst>
            <pc:docMk/>
            <pc:sldMk cId="2203610160" sldId="272"/>
            <ac:spMk id="16" creationId="{7029036A-2E66-DB25-6B19-CCDE5337907B}"/>
          </ac:spMkLst>
        </pc:spChg>
        <pc:spChg chg="add mod">
          <ac:chgData name="Arber, Charlie" userId="a4408506-200b-48fd-8fce-b836ccf79d22" providerId="ADAL" clId="{53086ABA-F489-E945-B22E-825D7E911253}" dt="2025-04-14T11:03:11.343" v="101" actId="1038"/>
          <ac:spMkLst>
            <pc:docMk/>
            <pc:sldMk cId="2203610160" sldId="272"/>
            <ac:spMk id="17" creationId="{D0030794-1712-25E4-309D-77A948227946}"/>
          </ac:spMkLst>
        </pc:spChg>
        <pc:spChg chg="add mod">
          <ac:chgData name="Arber, Charlie" userId="a4408506-200b-48fd-8fce-b836ccf79d22" providerId="ADAL" clId="{53086ABA-F489-E945-B22E-825D7E911253}" dt="2025-04-14T11:03:01.957" v="85" actId="12789"/>
          <ac:spMkLst>
            <pc:docMk/>
            <pc:sldMk cId="2203610160" sldId="272"/>
            <ac:spMk id="18" creationId="{80920990-B928-EB4B-71BE-59BE28B8959D}"/>
          </ac:spMkLst>
        </pc:spChg>
        <pc:spChg chg="add mod">
          <ac:chgData name="Arber, Charlie" userId="a4408506-200b-48fd-8fce-b836ccf79d22" providerId="ADAL" clId="{53086ABA-F489-E945-B22E-825D7E911253}" dt="2025-04-14T11:03:01.957" v="85" actId="12789"/>
          <ac:spMkLst>
            <pc:docMk/>
            <pc:sldMk cId="2203610160" sldId="272"/>
            <ac:spMk id="19" creationId="{B6C8B99D-7EB0-EB3E-5196-3BEC1B13C319}"/>
          </ac:spMkLst>
        </pc:spChg>
        <pc:picChg chg="add mod">
          <ac:chgData name="Arber, Charlie" userId="a4408506-200b-48fd-8fce-b836ccf79d22" providerId="ADAL" clId="{53086ABA-F489-E945-B22E-825D7E911253}" dt="2025-04-11T16:10:19.631" v="67" actId="1038"/>
          <ac:picMkLst>
            <pc:docMk/>
            <pc:sldMk cId="2203610160" sldId="272"/>
            <ac:picMk id="3" creationId="{C2076198-3113-D311-6C7B-0BB11C4F0921}"/>
          </ac:picMkLst>
        </pc:picChg>
        <pc:picChg chg="mod">
          <ac:chgData name="Arber, Charlie" userId="a4408506-200b-48fd-8fce-b836ccf79d22" providerId="ADAL" clId="{53086ABA-F489-E945-B22E-825D7E911253}" dt="2025-04-11T16:10:19.631" v="67" actId="1038"/>
          <ac:picMkLst>
            <pc:docMk/>
            <pc:sldMk cId="2203610160" sldId="272"/>
            <ac:picMk id="6" creationId="{2ED5D29E-6385-733E-4213-F995D0F26AF6}"/>
          </ac:picMkLst>
        </pc:picChg>
        <pc:picChg chg="mod">
          <ac:chgData name="Arber, Charlie" userId="a4408506-200b-48fd-8fce-b836ccf79d22" providerId="ADAL" clId="{53086ABA-F489-E945-B22E-825D7E911253}" dt="2025-04-11T16:10:19.631" v="67" actId="1038"/>
          <ac:picMkLst>
            <pc:docMk/>
            <pc:sldMk cId="2203610160" sldId="272"/>
            <ac:picMk id="8" creationId="{F8226B8F-C2DA-B12C-F7FB-CFF424870617}"/>
          </ac:picMkLst>
        </pc:picChg>
        <pc:picChg chg="mod">
          <ac:chgData name="Arber, Charlie" userId="a4408506-200b-48fd-8fce-b836ccf79d22" providerId="ADAL" clId="{53086ABA-F489-E945-B22E-825D7E911253}" dt="2025-04-11T16:10:19.631" v="67" actId="1038"/>
          <ac:picMkLst>
            <pc:docMk/>
            <pc:sldMk cId="2203610160" sldId="272"/>
            <ac:picMk id="11" creationId="{91D8AD32-6B4F-2817-D6B1-9A4C11B2D6C9}"/>
          </ac:picMkLst>
        </pc:picChg>
        <pc:cxnChg chg="add mod">
          <ac:chgData name="Arber, Charlie" userId="a4408506-200b-48fd-8fce-b836ccf79d22" providerId="ADAL" clId="{53086ABA-F489-E945-B22E-825D7E911253}" dt="2025-04-11T16:10:03.144" v="55" actId="1038"/>
          <ac:cxnSpMkLst>
            <pc:docMk/>
            <pc:sldMk cId="2203610160" sldId="272"/>
            <ac:cxnSpMk id="9" creationId="{F3AD3B27-40AA-4C6F-E272-C0AFB3782A56}"/>
          </ac:cxnSpMkLst>
        </pc:cxnChg>
      </pc:sldChg>
      <pc:sldChg chg="new">
        <pc:chgData name="Arber, Charlie" userId="a4408506-200b-48fd-8fce-b836ccf79d22" providerId="ADAL" clId="{53086ABA-F489-E945-B22E-825D7E911253}" dt="2025-04-14T10:57:40.746" v="69" actId="680"/>
        <pc:sldMkLst>
          <pc:docMk/>
          <pc:sldMk cId="2847703039" sldId="274"/>
        </pc:sldMkLst>
      </pc:sldChg>
      <pc:sldChg chg="new del">
        <pc:chgData name="Arber, Charlie" userId="a4408506-200b-48fd-8fce-b836ccf79d22" providerId="ADAL" clId="{53086ABA-F489-E945-B22E-825D7E911253}" dt="2025-04-14T10:57:45.503" v="72" actId="2696"/>
        <pc:sldMkLst>
          <pc:docMk/>
          <pc:sldMk cId="1199691451" sldId="275"/>
        </pc:sldMkLst>
      </pc:sldChg>
    </pc:docChg>
  </pc:docChgLst>
  <pc:docChgLst>
    <pc:chgData name="Arber, Charlie" userId="a4408506-200b-48fd-8fce-b836ccf79d22" providerId="ADAL" clId="{A337B549-51B1-C142-9639-1B128DCD7FBD}"/>
    <pc:docChg chg="custSel modSld">
      <pc:chgData name="Arber, Charlie" userId="a4408506-200b-48fd-8fce-b836ccf79d22" providerId="ADAL" clId="{A337B549-51B1-C142-9639-1B128DCD7FBD}" dt="2024-12-05T12:43:24.969" v="40" actId="12788"/>
      <pc:docMkLst>
        <pc:docMk/>
      </pc:docMkLst>
      <pc:sldChg chg="addSp delSp modSp mod">
        <pc:chgData name="Arber, Charlie" userId="a4408506-200b-48fd-8fce-b836ccf79d22" providerId="ADAL" clId="{A337B549-51B1-C142-9639-1B128DCD7FBD}" dt="2024-12-05T12:43:24.969" v="40" actId="12788"/>
        <pc:sldMkLst>
          <pc:docMk/>
          <pc:sldMk cId="1088065246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72F5-7EC2-3147-9CE5-F731DEDD5CF1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22BA3-D07A-784B-9866-198AC5637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1864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22BA3-D07A-784B-9866-198AC56371A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817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260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062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785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8123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869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79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230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236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70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15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519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3B60C-24E4-164F-A368-FCBE0E94B0C7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552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emf"/><Relationship Id="rId5" Type="http://schemas.openxmlformats.org/officeDocument/2006/relationships/image" Target="../media/image7.png"/><Relationship Id="rId10" Type="http://schemas.openxmlformats.org/officeDocument/2006/relationships/image" Target="../media/image12.emf"/><Relationship Id="rId4" Type="http://schemas.openxmlformats.org/officeDocument/2006/relationships/image" Target="../media/image6.png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image" Target="../media/image39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12" Type="http://schemas.openxmlformats.org/officeDocument/2006/relationships/image" Target="../media/image3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5" Type="http://schemas.openxmlformats.org/officeDocument/2006/relationships/image" Target="../media/image31.emf"/><Relationship Id="rId15" Type="http://schemas.openxmlformats.org/officeDocument/2006/relationships/image" Target="../media/image4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Relationship Id="rId14" Type="http://schemas.openxmlformats.org/officeDocument/2006/relationships/image" Target="../media/image40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13" Type="http://schemas.openxmlformats.org/officeDocument/2006/relationships/image" Target="../media/image53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12" Type="http://schemas.openxmlformats.org/officeDocument/2006/relationships/image" Target="../media/image52.png"/><Relationship Id="rId2" Type="http://schemas.openxmlformats.org/officeDocument/2006/relationships/image" Target="../media/image42.png"/><Relationship Id="rId16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11" Type="http://schemas.openxmlformats.org/officeDocument/2006/relationships/image" Target="../media/image51.png"/><Relationship Id="rId5" Type="http://schemas.openxmlformats.org/officeDocument/2006/relationships/image" Target="../media/image45.png"/><Relationship Id="rId15" Type="http://schemas.openxmlformats.org/officeDocument/2006/relationships/image" Target="../media/image5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Relationship Id="rId14" Type="http://schemas.openxmlformats.org/officeDocument/2006/relationships/image" Target="../media/image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B07B96-C915-1887-D9F8-718678511396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1F1B1F-1B8A-00E0-EAFD-8DC85F3035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755" b="50000"/>
          <a:stretch/>
        </p:blipFill>
        <p:spPr>
          <a:xfrm>
            <a:off x="1314249" y="2923262"/>
            <a:ext cx="7772400" cy="174941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28588C-3629-4A68-FCB0-813F652603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755" b="50000"/>
          <a:stretch/>
        </p:blipFill>
        <p:spPr>
          <a:xfrm>
            <a:off x="1314249" y="4821207"/>
            <a:ext cx="7772400" cy="174941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A026CA2-A537-4E1D-E296-CEB103CBB732}"/>
              </a:ext>
            </a:extLst>
          </p:cNvPr>
          <p:cNvSpPr txBox="1"/>
          <p:nvPr/>
        </p:nvSpPr>
        <p:spPr>
          <a:xfrm rot="16200000">
            <a:off x="129312" y="3644078"/>
            <a:ext cx="1749410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PSEN1 R278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7AE3E0-E999-1826-987B-1494DF0B10A3}"/>
              </a:ext>
            </a:extLst>
          </p:cNvPr>
          <p:cNvSpPr txBox="1"/>
          <p:nvPr/>
        </p:nvSpPr>
        <p:spPr>
          <a:xfrm rot="16200000">
            <a:off x="129312" y="5542023"/>
            <a:ext cx="1749410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Isogenic correcte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4C4262D-1436-4319-A90E-899F4832AC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3440" y="869107"/>
            <a:ext cx="4755169" cy="1729152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89BD9DD8-22E8-69BB-C9A1-3014518052C8}"/>
              </a:ext>
            </a:extLst>
          </p:cNvPr>
          <p:cNvSpPr/>
          <p:nvPr/>
        </p:nvSpPr>
        <p:spPr>
          <a:xfrm>
            <a:off x="4948779" y="702160"/>
            <a:ext cx="233916" cy="203044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150920-9E8E-5D8F-33D7-3355FE9A0E0E}"/>
              </a:ext>
            </a:extLst>
          </p:cNvPr>
          <p:cNvSpPr txBox="1"/>
          <p:nvPr/>
        </p:nvSpPr>
        <p:spPr>
          <a:xfrm>
            <a:off x="4279368" y="332828"/>
            <a:ext cx="1572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T&gt;G correc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DD3558-E4D0-BE1C-19C1-B99BF379C397}"/>
              </a:ext>
            </a:extLst>
          </p:cNvPr>
          <p:cNvSpPr txBox="1"/>
          <p:nvPr/>
        </p:nvSpPr>
        <p:spPr>
          <a:xfrm rot="16200000">
            <a:off x="144410" y="1573623"/>
            <a:ext cx="1729153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Isogenic correct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6691C6-F4EE-C85A-BD02-AC23CE6921F2}"/>
              </a:ext>
            </a:extLst>
          </p:cNvPr>
          <p:cNvSpPr txBox="1"/>
          <p:nvPr/>
        </p:nvSpPr>
        <p:spPr>
          <a:xfrm>
            <a:off x="850128" y="5408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D64BE3-0699-5FE5-659A-C2E03DC0F0BD}"/>
              </a:ext>
            </a:extLst>
          </p:cNvPr>
          <p:cNvSpPr txBox="1"/>
          <p:nvPr/>
        </p:nvSpPr>
        <p:spPr>
          <a:xfrm>
            <a:off x="850128" y="259682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64675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9F717E8-8B4B-B4F4-D8EF-3E164EEEABA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141" r="4165" b="38475"/>
          <a:stretch/>
        </p:blipFill>
        <p:spPr>
          <a:xfrm>
            <a:off x="827242" y="2432938"/>
            <a:ext cx="2416104" cy="26449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2E5D4F-5766-5C40-100D-F0369305DC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64"/>
          <a:stretch/>
        </p:blipFill>
        <p:spPr>
          <a:xfrm>
            <a:off x="827239" y="3128542"/>
            <a:ext cx="2416105" cy="33241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9A7BDC1-4E93-ACE4-00D0-BC69FBCBC8E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844" t="31285" r="320" b="18548"/>
          <a:stretch/>
        </p:blipFill>
        <p:spPr>
          <a:xfrm>
            <a:off x="827240" y="2743692"/>
            <a:ext cx="2416105" cy="332419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F03C5FE-7688-D0B9-99B6-DEE8025B3669}"/>
              </a:ext>
            </a:extLst>
          </p:cNvPr>
          <p:cNvSpPr txBox="1"/>
          <p:nvPr/>
        </p:nvSpPr>
        <p:spPr>
          <a:xfrm>
            <a:off x="3262028" y="2446250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PSEN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D37FC7-4D6B-D7A5-8501-C020ADF8F67E}"/>
              </a:ext>
            </a:extLst>
          </p:cNvPr>
          <p:cNvSpPr txBox="1"/>
          <p:nvPr/>
        </p:nvSpPr>
        <p:spPr>
          <a:xfrm>
            <a:off x="3262028" y="2782235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PSEN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153D83-7386-6581-793A-AA15B683EE6A}"/>
              </a:ext>
            </a:extLst>
          </p:cNvPr>
          <p:cNvSpPr txBox="1"/>
          <p:nvPr/>
        </p:nvSpPr>
        <p:spPr>
          <a:xfrm>
            <a:off x="3262029" y="3214035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GAPDH</a:t>
            </a:r>
          </a:p>
        </p:txBody>
      </p:sp>
      <p:pic>
        <p:nvPicPr>
          <p:cNvPr id="12" name="Picture 11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57E629DC-9472-4521-BF7A-63DE0CC0AD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165"/>
          <a:stretch/>
        </p:blipFill>
        <p:spPr>
          <a:xfrm>
            <a:off x="827242" y="1491719"/>
            <a:ext cx="2416104" cy="46506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0740DFC-28AC-408B-C3A7-E1EE8F818B12}"/>
              </a:ext>
            </a:extLst>
          </p:cNvPr>
          <p:cNvSpPr txBox="1"/>
          <p:nvPr/>
        </p:nvSpPr>
        <p:spPr>
          <a:xfrm>
            <a:off x="3262026" y="1593145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AP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002F4E-D08E-9C80-E2DC-D583D5CEA5E8}"/>
              </a:ext>
            </a:extLst>
          </p:cNvPr>
          <p:cNvSpPr txBox="1"/>
          <p:nvPr/>
        </p:nvSpPr>
        <p:spPr>
          <a:xfrm>
            <a:off x="3262025" y="3038828"/>
            <a:ext cx="46679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B401F55-C12A-19A9-F50A-77AA3D72E04D}"/>
              </a:ext>
            </a:extLst>
          </p:cNvPr>
          <p:cNvSpPr txBox="1"/>
          <p:nvPr/>
        </p:nvSpPr>
        <p:spPr>
          <a:xfrm rot="16200000">
            <a:off x="886455" y="932417"/>
            <a:ext cx="6495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Neuron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5C7366-D669-40F4-487F-413DFF2B5973}"/>
              </a:ext>
            </a:extLst>
          </p:cNvPr>
          <p:cNvSpPr txBox="1"/>
          <p:nvPr/>
        </p:nvSpPr>
        <p:spPr>
          <a:xfrm rot="16200000">
            <a:off x="1486828" y="889792"/>
            <a:ext cx="7617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Astrocyte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FEDD8C-E9D0-E904-86B1-C8AA9951374B}"/>
              </a:ext>
            </a:extLst>
          </p:cNvPr>
          <p:cNvSpPr txBox="1"/>
          <p:nvPr/>
        </p:nvSpPr>
        <p:spPr>
          <a:xfrm rot="16200000">
            <a:off x="2157568" y="932417"/>
            <a:ext cx="69442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Microgli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0452E96-2ACB-CF80-6BFA-22EE6F763173}"/>
              </a:ext>
            </a:extLst>
          </p:cNvPr>
          <p:cNvSpPr txBox="1"/>
          <p:nvPr/>
        </p:nvSpPr>
        <p:spPr>
          <a:xfrm rot="16200000">
            <a:off x="2810240" y="1046477"/>
            <a:ext cx="4700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Brain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3E50E4D-FF9B-D09B-B903-6B35BED65CB5}"/>
              </a:ext>
            </a:extLst>
          </p:cNvPr>
          <p:cNvCxnSpPr>
            <a:cxnSpLocks/>
          </p:cNvCxnSpPr>
          <p:nvPr/>
        </p:nvCxnSpPr>
        <p:spPr>
          <a:xfrm>
            <a:off x="972113" y="14150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CF9CEEF-9703-F9D3-1F2C-9D1F2297B812}"/>
              </a:ext>
            </a:extLst>
          </p:cNvPr>
          <p:cNvCxnSpPr>
            <a:cxnSpLocks/>
          </p:cNvCxnSpPr>
          <p:nvPr/>
        </p:nvCxnSpPr>
        <p:spPr>
          <a:xfrm>
            <a:off x="1628586" y="14150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1FA4039-EC2B-4292-2E58-1C11B617335C}"/>
              </a:ext>
            </a:extLst>
          </p:cNvPr>
          <p:cNvCxnSpPr>
            <a:cxnSpLocks/>
          </p:cNvCxnSpPr>
          <p:nvPr/>
        </p:nvCxnSpPr>
        <p:spPr>
          <a:xfrm>
            <a:off x="2265663" y="14150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6EB6F04-977E-3FE3-8F1F-34ADDA4D5E59}"/>
              </a:ext>
            </a:extLst>
          </p:cNvPr>
          <p:cNvCxnSpPr>
            <a:cxnSpLocks/>
          </p:cNvCxnSpPr>
          <p:nvPr/>
        </p:nvCxnSpPr>
        <p:spPr>
          <a:xfrm>
            <a:off x="2897388" y="1415059"/>
            <a:ext cx="2957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 descr="A red and green light on a square&#10;&#10;Description automatically generated">
            <a:extLst>
              <a:ext uri="{FF2B5EF4-FFF2-40B4-BE49-F238E27FC236}">
                <a16:creationId xmlns:a16="http://schemas.microsoft.com/office/drawing/2014/main" id="{D08C9C03-04D7-1581-EF12-CF84EC5AEA0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6213" t="39677" r="20340" b="47556"/>
          <a:stretch/>
        </p:blipFill>
        <p:spPr>
          <a:xfrm>
            <a:off x="827242" y="3704443"/>
            <a:ext cx="2055556" cy="41515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C208114-BEB8-D944-2690-BD1C1B92504A}"/>
              </a:ext>
            </a:extLst>
          </p:cNvPr>
          <p:cNvSpPr txBox="1"/>
          <p:nvPr/>
        </p:nvSpPr>
        <p:spPr>
          <a:xfrm>
            <a:off x="3262027" y="3701384"/>
            <a:ext cx="76167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>
                <a:solidFill>
                  <a:srgbClr val="00B050"/>
                </a:solidFill>
              </a:rPr>
              <a:t>sAPPβ </a:t>
            </a:r>
          </a:p>
          <a:p>
            <a:r>
              <a:rPr lang="en-GB" sz="1050">
                <a:solidFill>
                  <a:srgbClr val="FF0000"/>
                </a:solidFill>
              </a:rPr>
              <a:t>sAPP tota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0A30B4-DA8E-A6CD-BCC4-AA02FF799FC1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6B1895-2A5C-D50E-AC7B-1D59322AC378}"/>
              </a:ext>
            </a:extLst>
          </p:cNvPr>
          <p:cNvSpPr txBox="1"/>
          <p:nvPr/>
        </p:nvSpPr>
        <p:spPr>
          <a:xfrm>
            <a:off x="118974" y="157933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100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6207F96-9C8B-9D85-31F7-F667D3139598}"/>
              </a:ext>
            </a:extLst>
          </p:cNvPr>
          <p:cNvSpPr txBox="1"/>
          <p:nvPr/>
        </p:nvSpPr>
        <p:spPr>
          <a:xfrm>
            <a:off x="191855" y="2386391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25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F3DD3B1-4349-F699-46A2-691E0644AC7B}"/>
              </a:ext>
            </a:extLst>
          </p:cNvPr>
          <p:cNvSpPr txBox="1"/>
          <p:nvPr/>
        </p:nvSpPr>
        <p:spPr>
          <a:xfrm>
            <a:off x="187902" y="2652001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 dirty="0"/>
              <a:t>20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CCAB1F-AEAA-094C-5303-6AB81EF8534B}"/>
              </a:ext>
            </a:extLst>
          </p:cNvPr>
          <p:cNvSpPr txBox="1"/>
          <p:nvPr/>
        </p:nvSpPr>
        <p:spPr>
          <a:xfrm>
            <a:off x="187902" y="3149105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 dirty="0"/>
              <a:t>37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479A13-DA5D-25D6-0BD7-8F7029297D63}"/>
              </a:ext>
            </a:extLst>
          </p:cNvPr>
          <p:cNvSpPr txBox="1"/>
          <p:nvPr/>
        </p:nvSpPr>
        <p:spPr>
          <a:xfrm>
            <a:off x="119613" y="3661155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100kD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8B635499-D611-5481-4197-6E6F29F5BB4C}"/>
              </a:ext>
            </a:extLst>
          </p:cNvPr>
          <p:cNvCxnSpPr>
            <a:cxnSpLocks/>
          </p:cNvCxnSpPr>
          <p:nvPr/>
        </p:nvCxnSpPr>
        <p:spPr>
          <a:xfrm>
            <a:off x="656108" y="1712875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CAC4CEA-0D41-BD12-106D-63226BF9F801}"/>
              </a:ext>
            </a:extLst>
          </p:cNvPr>
          <p:cNvCxnSpPr>
            <a:cxnSpLocks/>
          </p:cNvCxnSpPr>
          <p:nvPr/>
        </p:nvCxnSpPr>
        <p:spPr>
          <a:xfrm>
            <a:off x="656108" y="2513349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96FD6F2-C375-F83B-A7CD-1DCC5F6B5C5C}"/>
              </a:ext>
            </a:extLst>
          </p:cNvPr>
          <p:cNvCxnSpPr>
            <a:cxnSpLocks/>
          </p:cNvCxnSpPr>
          <p:nvPr/>
        </p:nvCxnSpPr>
        <p:spPr>
          <a:xfrm>
            <a:off x="656108" y="2777488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706C9748-4FB2-3D53-6108-8EAAF902F536}"/>
              </a:ext>
            </a:extLst>
          </p:cNvPr>
          <p:cNvCxnSpPr>
            <a:cxnSpLocks/>
          </p:cNvCxnSpPr>
          <p:nvPr/>
        </p:nvCxnSpPr>
        <p:spPr>
          <a:xfrm>
            <a:off x="656108" y="3273010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58AC563-8151-C5C7-59F2-A7AB69266BE1}"/>
              </a:ext>
            </a:extLst>
          </p:cNvPr>
          <p:cNvCxnSpPr>
            <a:cxnSpLocks/>
          </p:cNvCxnSpPr>
          <p:nvPr/>
        </p:nvCxnSpPr>
        <p:spPr>
          <a:xfrm>
            <a:off x="656108" y="3786642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B2633CF-17C0-8F17-C51E-0D435AAC5309}"/>
              </a:ext>
            </a:extLst>
          </p:cNvPr>
          <p:cNvSpPr txBox="1"/>
          <p:nvPr/>
        </p:nvSpPr>
        <p:spPr>
          <a:xfrm>
            <a:off x="479036" y="8827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4B50F6C-80AC-CA76-087E-EC5FCF8A525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1726" t="73266" r="32308" b="1226"/>
          <a:stretch/>
        </p:blipFill>
        <p:spPr>
          <a:xfrm rot="5400000">
            <a:off x="3727229" y="1601617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9DEF772-2F57-5A4A-9B0F-F984F0B1094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567" t="47712" r="31467" b="26780"/>
          <a:stretch/>
        </p:blipFill>
        <p:spPr>
          <a:xfrm rot="5400000">
            <a:off x="3727229" y="4102640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409F3F4D-6BCC-6A1B-1D03-09B499CDFFE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3221" t="24492" r="30813" b="50000"/>
          <a:stretch/>
        </p:blipFill>
        <p:spPr>
          <a:xfrm rot="5400000">
            <a:off x="4944286" y="1605090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2D5ABF3-FF76-CB69-0710-381AE4D686E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350" r="31684" b="74492"/>
          <a:stretch/>
        </p:blipFill>
        <p:spPr>
          <a:xfrm rot="5400000">
            <a:off x="4944286" y="4102640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4247EBF1-2A77-F5A2-871D-3566A5F908E1}"/>
              </a:ext>
            </a:extLst>
          </p:cNvPr>
          <p:cNvSpPr txBox="1"/>
          <p:nvPr/>
        </p:nvSpPr>
        <p:spPr>
          <a:xfrm>
            <a:off x="4361918" y="615264"/>
            <a:ext cx="1122037" cy="276999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ontrol 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45C295-88FA-A0AA-05DB-115477513E8A}"/>
              </a:ext>
            </a:extLst>
          </p:cNvPr>
          <p:cNvSpPr txBox="1"/>
          <p:nvPr/>
        </p:nvSpPr>
        <p:spPr>
          <a:xfrm>
            <a:off x="5578975" y="615264"/>
            <a:ext cx="1122037" cy="276999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PSEN1 Y115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6AE0D17-208C-667F-7101-9EF466A49D66}"/>
              </a:ext>
            </a:extLst>
          </p:cNvPr>
          <p:cNvSpPr txBox="1"/>
          <p:nvPr/>
        </p:nvSpPr>
        <p:spPr>
          <a:xfrm rot="16200000">
            <a:off x="2932692" y="2024135"/>
            <a:ext cx="2391415" cy="277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Untreate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897328A-01C4-65B9-CB41-B40B2B982BB6}"/>
              </a:ext>
            </a:extLst>
          </p:cNvPr>
          <p:cNvSpPr txBox="1"/>
          <p:nvPr/>
        </p:nvSpPr>
        <p:spPr>
          <a:xfrm rot="16200000">
            <a:off x="2932693" y="4525159"/>
            <a:ext cx="2391414" cy="277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TNF⍺, IL1⍺, C1q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CD8D5CC-08FE-6C78-3B64-4755F4E7F98A}"/>
              </a:ext>
            </a:extLst>
          </p:cNvPr>
          <p:cNvCxnSpPr/>
          <p:nvPr/>
        </p:nvCxnSpPr>
        <p:spPr>
          <a:xfrm>
            <a:off x="4649474" y="4978195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C4E74A1-78E4-4361-B68A-2860ABF4BC10}"/>
              </a:ext>
            </a:extLst>
          </p:cNvPr>
          <p:cNvCxnSpPr/>
          <p:nvPr/>
        </p:nvCxnSpPr>
        <p:spPr>
          <a:xfrm>
            <a:off x="5084746" y="4775363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8AE2AC3-6005-2293-EF08-22BB91E5BACD}"/>
              </a:ext>
            </a:extLst>
          </p:cNvPr>
          <p:cNvCxnSpPr/>
          <p:nvPr/>
        </p:nvCxnSpPr>
        <p:spPr>
          <a:xfrm>
            <a:off x="5867573" y="5031923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E56FC03-880A-819B-D481-F0F0274F7822}"/>
              </a:ext>
            </a:extLst>
          </p:cNvPr>
          <p:cNvCxnSpPr/>
          <p:nvPr/>
        </p:nvCxnSpPr>
        <p:spPr>
          <a:xfrm>
            <a:off x="6289689" y="4829091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DE868139-02AE-39B2-9806-0B4DA2E0CB2D}"/>
              </a:ext>
            </a:extLst>
          </p:cNvPr>
          <p:cNvSpPr txBox="1"/>
          <p:nvPr/>
        </p:nvSpPr>
        <p:spPr>
          <a:xfrm>
            <a:off x="3943687" y="4059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CA72D3F-B4A8-E1D9-68BA-BED268CA9CEF}"/>
              </a:ext>
            </a:extLst>
          </p:cNvPr>
          <p:cNvSpPr txBox="1"/>
          <p:nvPr/>
        </p:nvSpPr>
        <p:spPr>
          <a:xfrm>
            <a:off x="6811496" y="1613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8E22B62-14C0-5841-2F9E-4FF078A9CFBA}"/>
              </a:ext>
            </a:extLst>
          </p:cNvPr>
          <p:cNvSpPr txBox="1"/>
          <p:nvPr/>
        </p:nvSpPr>
        <p:spPr>
          <a:xfrm>
            <a:off x="6801878" y="231822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2B94965-EC55-045C-8353-EF069DC5B2D8}"/>
              </a:ext>
            </a:extLst>
          </p:cNvPr>
          <p:cNvSpPr txBox="1"/>
          <p:nvPr/>
        </p:nvSpPr>
        <p:spPr>
          <a:xfrm>
            <a:off x="6817107" y="447508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pic>
        <p:nvPicPr>
          <p:cNvPr id="2" name="Picture 1" descr="A black and white photo of a square&#10;&#10;Description automatically generated">
            <a:extLst>
              <a:ext uri="{FF2B5EF4-FFF2-40B4-BE49-F238E27FC236}">
                <a16:creationId xmlns:a16="http://schemas.microsoft.com/office/drawing/2014/main" id="{9F641774-2AD0-FF1C-2948-8F44C8AFD20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634" t="69867" r="21903" b="19626"/>
          <a:stretch/>
        </p:blipFill>
        <p:spPr>
          <a:xfrm>
            <a:off x="824741" y="2001460"/>
            <a:ext cx="2418603" cy="38835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3BB1F02C-4D72-EEA5-0A6F-33F466222F79}"/>
              </a:ext>
            </a:extLst>
          </p:cNvPr>
          <p:cNvSpPr txBox="1"/>
          <p:nvPr/>
        </p:nvSpPr>
        <p:spPr>
          <a:xfrm>
            <a:off x="187902" y="2141649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 dirty="0"/>
              <a:t>10kDa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0048ADB-8810-6DD7-233D-3E3AB9A579BE}"/>
              </a:ext>
            </a:extLst>
          </p:cNvPr>
          <p:cNvCxnSpPr>
            <a:cxnSpLocks/>
          </p:cNvCxnSpPr>
          <p:nvPr/>
        </p:nvCxnSpPr>
        <p:spPr>
          <a:xfrm>
            <a:off x="656108" y="2267136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5C80D0F8-7AC7-C5F2-3763-9A2189BDA0E2}"/>
              </a:ext>
            </a:extLst>
          </p:cNvPr>
          <p:cNvSpPr txBox="1"/>
          <p:nvPr/>
        </p:nvSpPr>
        <p:spPr>
          <a:xfrm>
            <a:off x="3270080" y="2064308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APPctf</a:t>
            </a:r>
            <a:endParaRPr lang="en-GB" sz="1050" dirty="0"/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149CB310-6D9F-1096-1546-F2084D1B784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74265" y="161367"/>
            <a:ext cx="2233946" cy="203435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0CF7A283-D4C2-E7C7-8A05-EF65D167F6E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69866" y="2318224"/>
            <a:ext cx="2233946" cy="205181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ACA8774D-7A54-0431-9265-82F46A12D3E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69866" y="4492546"/>
            <a:ext cx="2233946" cy="205181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AFD48C1-6060-836C-C40A-66A54F1A990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84266" y="4646409"/>
            <a:ext cx="1580550" cy="1995249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310EA6EB-A8B6-509C-F5F0-B7EDAE699CFD}"/>
              </a:ext>
            </a:extLst>
          </p:cNvPr>
          <p:cNvSpPr txBox="1"/>
          <p:nvPr/>
        </p:nvSpPr>
        <p:spPr>
          <a:xfrm>
            <a:off x="780136" y="459607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0880652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5C68BB-0AFA-67FE-2D1C-420529AE2F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1464" y="1079592"/>
            <a:ext cx="2758603" cy="257193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8BC54FC-A73A-6189-B9E6-8F97140E23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7848" y="1079592"/>
            <a:ext cx="2974494" cy="257193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4F68638-645B-C10A-3696-F55A3E8CD2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208" y="1070371"/>
            <a:ext cx="3002475" cy="257193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859B588-65D8-9D1C-119A-803C1BA9DD39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2E3810-4A41-58DA-E115-5768D86FC377}"/>
              </a:ext>
            </a:extLst>
          </p:cNvPr>
          <p:cNvSpPr txBox="1"/>
          <p:nvPr/>
        </p:nvSpPr>
        <p:spPr>
          <a:xfrm>
            <a:off x="235973" y="7010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D0EA7F-9CA5-A285-2779-F1B7ED5A9D46}"/>
              </a:ext>
            </a:extLst>
          </p:cNvPr>
          <p:cNvSpPr txBox="1"/>
          <p:nvPr/>
        </p:nvSpPr>
        <p:spPr>
          <a:xfrm>
            <a:off x="3521464" y="7010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0BDFE58-20D7-6A0C-8340-D66AF7B2D012}"/>
              </a:ext>
            </a:extLst>
          </p:cNvPr>
          <p:cNvSpPr txBox="1"/>
          <p:nvPr/>
        </p:nvSpPr>
        <p:spPr>
          <a:xfrm>
            <a:off x="6516620" y="70103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C180B7-8086-8706-0002-A89C59AE0B65}"/>
              </a:ext>
            </a:extLst>
          </p:cNvPr>
          <p:cNvSpPr txBox="1"/>
          <p:nvPr/>
        </p:nvSpPr>
        <p:spPr>
          <a:xfrm>
            <a:off x="1961452" y="371515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BAA2BA-7EB3-2AF5-4A03-8985E23F4C14}"/>
              </a:ext>
            </a:extLst>
          </p:cNvPr>
          <p:cNvSpPr txBox="1"/>
          <p:nvPr/>
        </p:nvSpPr>
        <p:spPr>
          <a:xfrm>
            <a:off x="5017726" y="370376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5A9BD21-B861-C0C2-000D-DBD90BB983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30736" y="4073097"/>
            <a:ext cx="2971768" cy="257193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21FD1F3-89DF-7705-E020-E550FDBC6B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81232" y="4073097"/>
            <a:ext cx="2971768" cy="257193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46AB14F5-D360-09F9-1D9D-A5423BE3DF3B}"/>
              </a:ext>
            </a:extLst>
          </p:cNvPr>
          <p:cNvGrpSpPr/>
          <p:nvPr/>
        </p:nvGrpSpPr>
        <p:grpSpPr>
          <a:xfrm>
            <a:off x="8106976" y="5356892"/>
            <a:ext cx="1463578" cy="1270995"/>
            <a:chOff x="3754940" y="4899410"/>
            <a:chExt cx="1463578" cy="1270995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DA5F0B7-F1EE-543F-F17F-BBA06B07486A}"/>
                </a:ext>
              </a:extLst>
            </p:cNvPr>
            <p:cNvGrpSpPr/>
            <p:nvPr/>
          </p:nvGrpSpPr>
          <p:grpSpPr>
            <a:xfrm>
              <a:off x="3860706" y="4899410"/>
              <a:ext cx="1357812" cy="1270995"/>
              <a:chOff x="5893622" y="4697653"/>
              <a:chExt cx="1357812" cy="1270995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AC3CE31-FBDC-1A77-9737-56E11270F70E}"/>
                  </a:ext>
                </a:extLst>
              </p:cNvPr>
              <p:cNvSpPr txBox="1"/>
              <p:nvPr/>
            </p:nvSpPr>
            <p:spPr>
              <a:xfrm>
                <a:off x="5970314" y="5283237"/>
                <a:ext cx="12811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/>
                  <a:t>Isogenic ctrl (int4del)</a:t>
                </a:r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3CE9F3C2-6103-87BE-F29E-10D4002E8096}"/>
                  </a:ext>
                </a:extLst>
              </p:cNvPr>
              <p:cNvGrpSpPr/>
              <p:nvPr/>
            </p:nvGrpSpPr>
            <p:grpSpPr>
              <a:xfrm>
                <a:off x="5893622" y="4697653"/>
                <a:ext cx="992327" cy="1270995"/>
                <a:chOff x="5893622" y="4697653"/>
                <a:chExt cx="992327" cy="1270995"/>
              </a:xfrm>
            </p:grpSpPr>
            <p:sp>
              <p:nvSpPr>
                <p:cNvPr id="22" name="Rounded Rectangle 21">
                  <a:extLst>
                    <a:ext uri="{FF2B5EF4-FFF2-40B4-BE49-F238E27FC236}">
                      <a16:creationId xmlns:a16="http://schemas.microsoft.com/office/drawing/2014/main" id="{0B50A50E-C642-08D2-EEC2-3312836BC907}"/>
                    </a:ext>
                  </a:extLst>
                </p:cNvPr>
                <p:cNvSpPr/>
                <p:nvPr/>
              </p:nvSpPr>
              <p:spPr>
                <a:xfrm>
                  <a:off x="5893622" y="4789553"/>
                  <a:ext cx="66972" cy="70179"/>
                </a:xfrm>
                <a:prstGeom prst="roundRect">
                  <a:avLst/>
                </a:prstGeom>
                <a:solidFill>
                  <a:srgbClr val="94219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3" name="Rounded Rectangle 22">
                  <a:extLst>
                    <a:ext uri="{FF2B5EF4-FFF2-40B4-BE49-F238E27FC236}">
                      <a16:creationId xmlns:a16="http://schemas.microsoft.com/office/drawing/2014/main" id="{F5519BEE-FB12-D86F-5C61-21A7C7C17267}"/>
                    </a:ext>
                  </a:extLst>
                </p:cNvPr>
                <p:cNvSpPr/>
                <p:nvPr/>
              </p:nvSpPr>
              <p:spPr>
                <a:xfrm>
                  <a:off x="5893622" y="4935610"/>
                  <a:ext cx="66972" cy="70179"/>
                </a:xfrm>
                <a:prstGeom prst="roundRect">
                  <a:avLst/>
                </a:prstGeom>
                <a:solidFill>
                  <a:srgbClr val="53599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4" name="Rounded Rectangle 23">
                  <a:extLst>
                    <a:ext uri="{FF2B5EF4-FFF2-40B4-BE49-F238E27FC236}">
                      <a16:creationId xmlns:a16="http://schemas.microsoft.com/office/drawing/2014/main" id="{0DD90A4B-22B1-EFD3-9F46-CE5EDCB4C52F}"/>
                    </a:ext>
                  </a:extLst>
                </p:cNvPr>
                <p:cNvSpPr/>
                <p:nvPr/>
              </p:nvSpPr>
              <p:spPr>
                <a:xfrm>
                  <a:off x="5893622" y="5081667"/>
                  <a:ext cx="66972" cy="70179"/>
                </a:xfrm>
                <a:prstGeom prst="roundRect">
                  <a:avLst/>
                </a:prstGeom>
                <a:solidFill>
                  <a:srgbClr val="338BA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5" name="Rounded Rectangle 24">
                  <a:extLst>
                    <a:ext uri="{FF2B5EF4-FFF2-40B4-BE49-F238E27FC236}">
                      <a16:creationId xmlns:a16="http://schemas.microsoft.com/office/drawing/2014/main" id="{3218476C-BDC4-2315-CA24-DD22D531A5B8}"/>
                    </a:ext>
                  </a:extLst>
                </p:cNvPr>
                <p:cNvSpPr/>
                <p:nvPr/>
              </p:nvSpPr>
              <p:spPr>
                <a:xfrm>
                  <a:off x="5893622" y="5373781"/>
                  <a:ext cx="66972" cy="70179"/>
                </a:xfrm>
                <a:prstGeom prst="roundRect">
                  <a:avLst/>
                </a:prstGeom>
                <a:solidFill>
                  <a:srgbClr val="21B295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6" name="Rounded Rectangle 25">
                  <a:extLst>
                    <a:ext uri="{FF2B5EF4-FFF2-40B4-BE49-F238E27FC236}">
                      <a16:creationId xmlns:a16="http://schemas.microsoft.com/office/drawing/2014/main" id="{80F365F6-AA3D-D870-FED1-CD06274EFF3F}"/>
                    </a:ext>
                  </a:extLst>
                </p:cNvPr>
                <p:cNvSpPr/>
                <p:nvPr/>
              </p:nvSpPr>
              <p:spPr>
                <a:xfrm>
                  <a:off x="5893622" y="5519838"/>
                  <a:ext cx="66972" cy="70179"/>
                </a:xfrm>
                <a:prstGeom prst="roundRect">
                  <a:avLst/>
                </a:prstGeom>
                <a:solidFill>
                  <a:srgbClr val="89D462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7" name="Rounded Rectangle 26">
                  <a:extLst>
                    <a:ext uri="{FF2B5EF4-FFF2-40B4-BE49-F238E27FC236}">
                      <a16:creationId xmlns:a16="http://schemas.microsoft.com/office/drawing/2014/main" id="{3B0DB3F5-F54E-2BA0-6A1E-883CF9C06718}"/>
                    </a:ext>
                  </a:extLst>
                </p:cNvPr>
                <p:cNvSpPr/>
                <p:nvPr/>
              </p:nvSpPr>
              <p:spPr>
                <a:xfrm>
                  <a:off x="5893622" y="5665895"/>
                  <a:ext cx="66972" cy="70179"/>
                </a:xfrm>
                <a:prstGeom prst="roundRect">
                  <a:avLst/>
                </a:prstGeom>
                <a:solidFill>
                  <a:srgbClr val="FDE82F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8" name="Rounded Rectangle 27">
                  <a:extLst>
                    <a:ext uri="{FF2B5EF4-FFF2-40B4-BE49-F238E27FC236}">
                      <a16:creationId xmlns:a16="http://schemas.microsoft.com/office/drawing/2014/main" id="{36CB41E5-2FC2-5FB9-BBD5-4B1C8A5CBF1A}"/>
                    </a:ext>
                  </a:extLst>
                </p:cNvPr>
                <p:cNvSpPr/>
                <p:nvPr/>
              </p:nvSpPr>
              <p:spPr>
                <a:xfrm>
                  <a:off x="5893622" y="5811955"/>
                  <a:ext cx="66972" cy="70179"/>
                </a:xfrm>
                <a:prstGeom prst="roundRect">
                  <a:avLst/>
                </a:prstGeom>
                <a:solidFill>
                  <a:srgbClr val="571367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9" name="Rounded Rectangle 28">
                  <a:extLst>
                    <a:ext uri="{FF2B5EF4-FFF2-40B4-BE49-F238E27FC236}">
                      <a16:creationId xmlns:a16="http://schemas.microsoft.com/office/drawing/2014/main" id="{4880D57F-E98F-FDD7-48E8-D7C0546A6B58}"/>
                    </a:ext>
                  </a:extLst>
                </p:cNvPr>
                <p:cNvSpPr/>
                <p:nvPr/>
              </p:nvSpPr>
              <p:spPr>
                <a:xfrm>
                  <a:off x="5893622" y="5227724"/>
                  <a:ext cx="66972" cy="70179"/>
                </a:xfrm>
                <a:prstGeom prst="roundRect">
                  <a:avLst/>
                </a:prstGeom>
                <a:solidFill>
                  <a:srgbClr val="A8A9A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50A9AA39-78D7-0755-6F3D-E11B1D75E6B2}"/>
                    </a:ext>
                  </a:extLst>
                </p:cNvPr>
                <p:cNvSpPr txBox="1"/>
                <p:nvPr/>
              </p:nvSpPr>
              <p:spPr>
                <a:xfrm>
                  <a:off x="5970314" y="4697653"/>
                  <a:ext cx="4363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Ctrl1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B01B3312-2C9B-8E0D-2B5C-6AEA3109F4D1}"/>
                    </a:ext>
                  </a:extLst>
                </p:cNvPr>
                <p:cNvSpPr txBox="1"/>
                <p:nvPr/>
              </p:nvSpPr>
              <p:spPr>
                <a:xfrm>
                  <a:off x="5970314" y="4844049"/>
                  <a:ext cx="4363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Ctrl2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5F90D53D-9BEE-C800-07E5-8102A7A55CB3}"/>
                    </a:ext>
                  </a:extLst>
                </p:cNvPr>
                <p:cNvSpPr txBox="1"/>
                <p:nvPr/>
              </p:nvSpPr>
              <p:spPr>
                <a:xfrm>
                  <a:off x="5970314" y="4990445"/>
                  <a:ext cx="4363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Ctrl3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8F9F4072-1450-181F-A029-D1BDD800745F}"/>
                    </a:ext>
                  </a:extLst>
                </p:cNvPr>
                <p:cNvSpPr txBox="1"/>
                <p:nvPr/>
              </p:nvSpPr>
              <p:spPr>
                <a:xfrm>
                  <a:off x="5970314" y="5136841"/>
                  <a:ext cx="4363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Ctrl4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30316529-D431-CAB7-207D-637F71CBB858}"/>
                    </a:ext>
                  </a:extLst>
                </p:cNvPr>
                <p:cNvSpPr txBox="1"/>
                <p:nvPr/>
              </p:nvSpPr>
              <p:spPr>
                <a:xfrm>
                  <a:off x="5970314" y="5429633"/>
                  <a:ext cx="9156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PSEN1 int4del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D9C8DD15-4993-CCFD-06F4-5A03680568CA}"/>
                    </a:ext>
                  </a:extLst>
                </p:cNvPr>
                <p:cNvSpPr txBox="1"/>
                <p:nvPr/>
              </p:nvSpPr>
              <p:spPr>
                <a:xfrm>
                  <a:off x="5970314" y="5576029"/>
                  <a:ext cx="8899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PSEN1 Y115H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E0F16F21-3CA3-36D6-7FD5-452C3F77C519}"/>
                    </a:ext>
                  </a:extLst>
                </p:cNvPr>
                <p:cNvSpPr txBox="1"/>
                <p:nvPr/>
              </p:nvSpPr>
              <p:spPr>
                <a:xfrm>
                  <a:off x="5970314" y="5722427"/>
                  <a:ext cx="84830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/>
                    <a:t>PSEN1 R278I</a:t>
                  </a:r>
                </a:p>
              </p:txBody>
            </p:sp>
          </p:grpSp>
        </p:grpSp>
        <p:sp>
          <p:nvSpPr>
            <p:cNvPr id="18" name="Rounded Rectangle 17">
              <a:extLst>
                <a:ext uri="{FF2B5EF4-FFF2-40B4-BE49-F238E27FC236}">
                  <a16:creationId xmlns:a16="http://schemas.microsoft.com/office/drawing/2014/main" id="{358D7535-DB15-171C-AA4E-324FE9CAA72E}"/>
                </a:ext>
              </a:extLst>
            </p:cNvPr>
            <p:cNvSpPr/>
            <p:nvPr/>
          </p:nvSpPr>
          <p:spPr>
            <a:xfrm>
              <a:off x="3754940" y="4991310"/>
              <a:ext cx="63640" cy="654407"/>
            </a:xfrm>
            <a:prstGeom prst="roundRect">
              <a:avLst/>
            </a:prstGeom>
            <a:solidFill>
              <a:srgbClr val="008E4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ounded Rectangle 18">
              <a:extLst>
                <a:ext uri="{FF2B5EF4-FFF2-40B4-BE49-F238E27FC236}">
                  <a16:creationId xmlns:a16="http://schemas.microsoft.com/office/drawing/2014/main" id="{F8B95973-056A-2D02-4C8E-32A5DD9283A4}"/>
                </a:ext>
              </a:extLst>
            </p:cNvPr>
            <p:cNvSpPr/>
            <p:nvPr/>
          </p:nvSpPr>
          <p:spPr>
            <a:xfrm>
              <a:off x="3754940" y="5716297"/>
              <a:ext cx="63640" cy="367593"/>
            </a:xfrm>
            <a:prstGeom prst="roundRect">
              <a:avLst/>
            </a:prstGeom>
            <a:solidFill>
              <a:srgbClr val="9437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192687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33B5D5-2337-0FAB-F92B-19E27522EF13}"/>
              </a:ext>
            </a:extLst>
          </p:cNvPr>
          <p:cNvSpPr txBox="1"/>
          <p:nvPr/>
        </p:nvSpPr>
        <p:spPr>
          <a:xfrm>
            <a:off x="169817" y="70409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4</a:t>
            </a:r>
          </a:p>
        </p:txBody>
      </p:sp>
      <p:pic>
        <p:nvPicPr>
          <p:cNvPr id="6" name="Picture 5" descr="A diagram of a graph&#10;&#10;Description automatically generated">
            <a:extLst>
              <a:ext uri="{FF2B5EF4-FFF2-40B4-BE49-F238E27FC236}">
                <a16:creationId xmlns:a16="http://schemas.microsoft.com/office/drawing/2014/main" id="{2ED5D29E-6385-733E-4213-F995D0F26A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354" y="821748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79D3050-084D-F763-8631-822FAC4EAB1B}"/>
              </a:ext>
            </a:extLst>
          </p:cNvPr>
          <p:cNvSpPr txBox="1"/>
          <p:nvPr/>
        </p:nvSpPr>
        <p:spPr>
          <a:xfrm>
            <a:off x="312354" y="423027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Untreated control vs Untreated PSEN1</a:t>
            </a:r>
          </a:p>
        </p:txBody>
      </p:sp>
      <p:pic>
        <p:nvPicPr>
          <p:cNvPr id="11" name="Picture 10" descr="A graph of red and blue dots&#10;&#10;Description automatically generated">
            <a:extLst>
              <a:ext uri="{FF2B5EF4-FFF2-40B4-BE49-F238E27FC236}">
                <a16:creationId xmlns:a16="http://schemas.microsoft.com/office/drawing/2014/main" id="{91D8AD32-6B4F-2817-D6B1-9A4C11B2D6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7365" y="821748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586BDE1-048F-422F-6A03-1726C22A039A}"/>
              </a:ext>
            </a:extLst>
          </p:cNvPr>
          <p:cNvSpPr txBox="1"/>
          <p:nvPr/>
        </p:nvSpPr>
        <p:spPr>
          <a:xfrm>
            <a:off x="3507364" y="426572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ontrol untreated vs Control TI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8AD89E-2098-DAD5-1FC0-D481681EF6DD}"/>
              </a:ext>
            </a:extLst>
          </p:cNvPr>
          <p:cNvSpPr txBox="1"/>
          <p:nvPr/>
        </p:nvSpPr>
        <p:spPr>
          <a:xfrm>
            <a:off x="6702374" y="423027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EN1 untreated vs PSEN1 TI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8226B8F-C2DA-B12C-F7FB-CFF4248706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02374" y="821748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2076198-3113-D311-6C7B-0BB11C4F092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15543" b="19036"/>
          <a:stretch/>
        </p:blipFill>
        <p:spPr>
          <a:xfrm>
            <a:off x="4772157" y="3909726"/>
            <a:ext cx="3958547" cy="1930707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3AD3B27-40AA-4C6F-E272-C0AFB3782A56}"/>
              </a:ext>
            </a:extLst>
          </p:cNvPr>
          <p:cNvCxnSpPr>
            <a:cxnSpLocks/>
          </p:cNvCxnSpPr>
          <p:nvPr/>
        </p:nvCxnSpPr>
        <p:spPr>
          <a:xfrm flipH="1">
            <a:off x="4937943" y="6620789"/>
            <a:ext cx="1446010" cy="0"/>
          </a:xfrm>
          <a:prstGeom prst="straightConnector1">
            <a:avLst/>
          </a:prstGeom>
          <a:ln w="38100">
            <a:solidFill>
              <a:srgbClr val="37A86D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4A761C0-38B0-53D2-99BF-C2FFF29F49BA}"/>
              </a:ext>
            </a:extLst>
          </p:cNvPr>
          <p:cNvSpPr txBox="1"/>
          <p:nvPr/>
        </p:nvSpPr>
        <p:spPr>
          <a:xfrm>
            <a:off x="6383953" y="6495702"/>
            <a:ext cx="12538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solidFill>
                  <a:srgbClr val="37A86D"/>
                </a:solidFill>
              </a:rPr>
              <a:t>More inflammatory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29036A-2E66-DB25-6B19-CCDE5337907B}"/>
              </a:ext>
            </a:extLst>
          </p:cNvPr>
          <p:cNvSpPr txBox="1"/>
          <p:nvPr/>
        </p:nvSpPr>
        <p:spPr>
          <a:xfrm>
            <a:off x="4466083" y="344178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0030794-1712-25E4-309D-77A948227946}"/>
              </a:ext>
            </a:extLst>
          </p:cNvPr>
          <p:cNvSpPr txBox="1"/>
          <p:nvPr/>
        </p:nvSpPr>
        <p:spPr>
          <a:xfrm>
            <a:off x="35283" y="3947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0920990-B928-EB4B-71BE-59BE28B8959D}"/>
              </a:ext>
            </a:extLst>
          </p:cNvPr>
          <p:cNvSpPr txBox="1"/>
          <p:nvPr/>
        </p:nvSpPr>
        <p:spPr>
          <a:xfrm>
            <a:off x="3507364" y="3947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6C8B99D-7EB0-EB3E-5196-3BEC1B13C319}"/>
              </a:ext>
            </a:extLst>
          </p:cNvPr>
          <p:cNvSpPr txBox="1"/>
          <p:nvPr/>
        </p:nvSpPr>
        <p:spPr>
          <a:xfrm>
            <a:off x="6702374" y="3947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C5E64B6-F9F4-39EE-A37A-7B64F91702A8}"/>
              </a:ext>
            </a:extLst>
          </p:cNvPr>
          <p:cNvSpPr txBox="1"/>
          <p:nvPr/>
        </p:nvSpPr>
        <p:spPr>
          <a:xfrm rot="5400000">
            <a:off x="7419004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C40C47-0845-1F0D-D745-9439955F9C8B}"/>
              </a:ext>
            </a:extLst>
          </p:cNvPr>
          <p:cNvSpPr txBox="1"/>
          <p:nvPr/>
        </p:nvSpPr>
        <p:spPr>
          <a:xfrm rot="5400000">
            <a:off x="7302931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9AE50E-765E-91A2-7E65-17EFA5552774}"/>
              </a:ext>
            </a:extLst>
          </p:cNvPr>
          <p:cNvSpPr txBox="1"/>
          <p:nvPr/>
        </p:nvSpPr>
        <p:spPr>
          <a:xfrm rot="5400000">
            <a:off x="7228047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66DE50C-112D-5A12-5AD4-DAA260DF07FD}"/>
              </a:ext>
            </a:extLst>
          </p:cNvPr>
          <p:cNvSpPr txBox="1"/>
          <p:nvPr/>
        </p:nvSpPr>
        <p:spPr>
          <a:xfrm rot="5400000">
            <a:off x="7357822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815F47-F539-20F3-736B-8906A582F416}"/>
              </a:ext>
            </a:extLst>
          </p:cNvPr>
          <p:cNvSpPr txBox="1"/>
          <p:nvPr/>
        </p:nvSpPr>
        <p:spPr>
          <a:xfrm rot="5400000">
            <a:off x="6618540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DE6331D-7B9E-4C23-A086-A01AC16AF509}"/>
              </a:ext>
            </a:extLst>
          </p:cNvPr>
          <p:cNvSpPr txBox="1"/>
          <p:nvPr/>
        </p:nvSpPr>
        <p:spPr>
          <a:xfrm rot="5400000">
            <a:off x="6495657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0ED8F49-A18E-857F-7371-8120B717BBB1}"/>
              </a:ext>
            </a:extLst>
          </p:cNvPr>
          <p:cNvSpPr txBox="1"/>
          <p:nvPr/>
        </p:nvSpPr>
        <p:spPr>
          <a:xfrm rot="5400000">
            <a:off x="6676090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E276D1F-1847-7739-22DC-7373A36FEFC1}"/>
              </a:ext>
            </a:extLst>
          </p:cNvPr>
          <p:cNvSpPr txBox="1"/>
          <p:nvPr/>
        </p:nvSpPr>
        <p:spPr>
          <a:xfrm rot="5400000">
            <a:off x="7135414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3107D48-F57D-B422-28E7-3AB45A5B3948}"/>
              </a:ext>
            </a:extLst>
          </p:cNvPr>
          <p:cNvSpPr txBox="1"/>
          <p:nvPr/>
        </p:nvSpPr>
        <p:spPr>
          <a:xfrm rot="5400000">
            <a:off x="7071109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8B20E97-5675-1E72-159B-E504B16878A0}"/>
              </a:ext>
            </a:extLst>
          </p:cNvPr>
          <p:cNvSpPr txBox="1"/>
          <p:nvPr/>
        </p:nvSpPr>
        <p:spPr>
          <a:xfrm rot="5400000">
            <a:off x="6277287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439D488-F2DB-D497-1256-D243961056E6}"/>
              </a:ext>
            </a:extLst>
          </p:cNvPr>
          <p:cNvSpPr txBox="1"/>
          <p:nvPr/>
        </p:nvSpPr>
        <p:spPr>
          <a:xfrm rot="5400000">
            <a:off x="6800582" y="6075434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>
                <a:solidFill>
                  <a:srgbClr val="0070C0"/>
                </a:solidFill>
              </a:rPr>
              <a:t>Fetal</a:t>
            </a:r>
            <a:endParaRPr lang="en-GB" sz="600" dirty="0">
              <a:solidFill>
                <a:srgbClr val="0070C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766C41A-CE32-C4D1-714A-875E981FF2EA}"/>
              </a:ext>
            </a:extLst>
          </p:cNvPr>
          <p:cNvSpPr txBox="1"/>
          <p:nvPr/>
        </p:nvSpPr>
        <p:spPr>
          <a:xfrm rot="5400000">
            <a:off x="6864510" y="6075434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>
                <a:solidFill>
                  <a:srgbClr val="0070C0"/>
                </a:solidFill>
              </a:rPr>
              <a:t>Fetal</a:t>
            </a:r>
            <a:endParaRPr lang="en-GB" sz="600" dirty="0">
              <a:solidFill>
                <a:srgbClr val="0070C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1134BBE-D749-E0E3-7E84-F31D363A225C}"/>
              </a:ext>
            </a:extLst>
          </p:cNvPr>
          <p:cNvSpPr txBox="1"/>
          <p:nvPr/>
        </p:nvSpPr>
        <p:spPr>
          <a:xfrm rot="5400000">
            <a:off x="4907877" y="6075434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>
                <a:solidFill>
                  <a:srgbClr val="0070C0"/>
                </a:solidFill>
              </a:rPr>
              <a:t>Fetal</a:t>
            </a:r>
            <a:endParaRPr lang="en-GB" sz="600" dirty="0">
              <a:solidFill>
                <a:srgbClr val="0070C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F0E33C-990A-BB0E-0A2E-91A217E893DF}"/>
              </a:ext>
            </a:extLst>
          </p:cNvPr>
          <p:cNvSpPr txBox="1"/>
          <p:nvPr/>
        </p:nvSpPr>
        <p:spPr>
          <a:xfrm rot="5400000">
            <a:off x="5276188" y="6075434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>
                <a:solidFill>
                  <a:srgbClr val="0070C0"/>
                </a:solidFill>
              </a:rPr>
              <a:t>Fetal</a:t>
            </a:r>
            <a:endParaRPr lang="en-GB" sz="600" dirty="0">
              <a:solidFill>
                <a:srgbClr val="0070C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6DE5E85-80F2-99CA-1243-00C4EAF67F23}"/>
              </a:ext>
            </a:extLst>
          </p:cNvPr>
          <p:cNvSpPr txBox="1"/>
          <p:nvPr/>
        </p:nvSpPr>
        <p:spPr>
          <a:xfrm rot="5400000">
            <a:off x="6003360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E3AE2BB-FAF1-CDCC-87A7-954AC8042162}"/>
              </a:ext>
            </a:extLst>
          </p:cNvPr>
          <p:cNvSpPr txBox="1"/>
          <p:nvPr/>
        </p:nvSpPr>
        <p:spPr>
          <a:xfrm rot="5400000">
            <a:off x="5455909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738369F-AC95-9FBA-4E7F-DFE378639742}"/>
              </a:ext>
            </a:extLst>
          </p:cNvPr>
          <p:cNvSpPr txBox="1"/>
          <p:nvPr/>
        </p:nvSpPr>
        <p:spPr>
          <a:xfrm rot="5400000">
            <a:off x="6376869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CD7EBE7-4325-A278-3B6A-E956A44C0D5E}"/>
              </a:ext>
            </a:extLst>
          </p:cNvPr>
          <p:cNvSpPr txBox="1"/>
          <p:nvPr/>
        </p:nvSpPr>
        <p:spPr>
          <a:xfrm rot="5400000">
            <a:off x="4974337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C9BAB3B-F627-0A4D-966F-1012573A7FA0}"/>
              </a:ext>
            </a:extLst>
          </p:cNvPr>
          <p:cNvSpPr txBox="1"/>
          <p:nvPr/>
        </p:nvSpPr>
        <p:spPr>
          <a:xfrm rot="5400000">
            <a:off x="6924118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3D3D7A3-0004-B934-2C52-82B0EFD82EC3}"/>
              </a:ext>
            </a:extLst>
          </p:cNvPr>
          <p:cNvSpPr txBox="1"/>
          <p:nvPr/>
        </p:nvSpPr>
        <p:spPr>
          <a:xfrm rot="5400000">
            <a:off x="6894422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2D802D9-B1C2-71A2-7B6A-94ED50EBA0C0}"/>
              </a:ext>
            </a:extLst>
          </p:cNvPr>
          <p:cNvSpPr txBox="1"/>
          <p:nvPr/>
        </p:nvSpPr>
        <p:spPr>
          <a:xfrm rot="5400000">
            <a:off x="6834997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C1E8F12-2C44-12D5-A34F-1FE437A8B4DB}"/>
              </a:ext>
            </a:extLst>
          </p:cNvPr>
          <p:cNvSpPr txBox="1"/>
          <p:nvPr/>
        </p:nvSpPr>
        <p:spPr>
          <a:xfrm rot="5400000">
            <a:off x="6107100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3C71215-84FC-63AC-1841-4C7D43F66DAB}"/>
              </a:ext>
            </a:extLst>
          </p:cNvPr>
          <p:cNvSpPr txBox="1"/>
          <p:nvPr/>
        </p:nvSpPr>
        <p:spPr>
          <a:xfrm rot="5400000">
            <a:off x="5378891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B7CB8F8-EDB2-5532-7CE3-E4165C5259AF}"/>
              </a:ext>
            </a:extLst>
          </p:cNvPr>
          <p:cNvSpPr txBox="1"/>
          <p:nvPr/>
        </p:nvSpPr>
        <p:spPr>
          <a:xfrm rot="5400000">
            <a:off x="5256231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4EE0A9-F6EA-0F2A-E5D9-43185BE94B81}"/>
              </a:ext>
            </a:extLst>
          </p:cNvPr>
          <p:cNvSpPr txBox="1"/>
          <p:nvPr/>
        </p:nvSpPr>
        <p:spPr>
          <a:xfrm rot="5400000">
            <a:off x="4522780" y="6216499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int4de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1387D3B-CC2D-F1F6-3F47-E21D52FC1D9A}"/>
              </a:ext>
            </a:extLst>
          </p:cNvPr>
          <p:cNvSpPr txBox="1"/>
          <p:nvPr/>
        </p:nvSpPr>
        <p:spPr>
          <a:xfrm rot="5400000">
            <a:off x="6602456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3B8701F-64FB-BB1A-F791-51683BFF2DC3}"/>
              </a:ext>
            </a:extLst>
          </p:cNvPr>
          <p:cNvSpPr txBox="1"/>
          <p:nvPr/>
        </p:nvSpPr>
        <p:spPr>
          <a:xfrm rot="5400000">
            <a:off x="6424625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7E7D719-2F08-584B-4EFF-A6D40BDF46FE}"/>
              </a:ext>
            </a:extLst>
          </p:cNvPr>
          <p:cNvSpPr txBox="1"/>
          <p:nvPr/>
        </p:nvSpPr>
        <p:spPr>
          <a:xfrm rot="5400000">
            <a:off x="6301701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8B3EFD6-482C-D842-4FF0-F82DC00A74D0}"/>
              </a:ext>
            </a:extLst>
          </p:cNvPr>
          <p:cNvSpPr txBox="1"/>
          <p:nvPr/>
        </p:nvSpPr>
        <p:spPr>
          <a:xfrm rot="5400000">
            <a:off x="5688261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02EA13F-6E63-9090-11B9-055BEE1F17BB}"/>
              </a:ext>
            </a:extLst>
          </p:cNvPr>
          <p:cNvSpPr txBox="1"/>
          <p:nvPr/>
        </p:nvSpPr>
        <p:spPr>
          <a:xfrm rot="5400000">
            <a:off x="5633370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9E51061-C73C-BB7A-BA3F-6D6EC9589FDC}"/>
              </a:ext>
            </a:extLst>
          </p:cNvPr>
          <p:cNvSpPr txBox="1"/>
          <p:nvPr/>
        </p:nvSpPr>
        <p:spPr>
          <a:xfrm rot="5400000">
            <a:off x="5014288" y="6207682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Y115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94BEF16-7D82-A4D0-F6FB-BFE97B24216E}"/>
              </a:ext>
            </a:extLst>
          </p:cNvPr>
          <p:cNvSpPr txBox="1"/>
          <p:nvPr/>
        </p:nvSpPr>
        <p:spPr>
          <a:xfrm rot="5400000">
            <a:off x="4695699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4852571-D8C9-63EF-A9D6-C7B808E2B358}"/>
              </a:ext>
            </a:extLst>
          </p:cNvPr>
          <p:cNvSpPr txBox="1"/>
          <p:nvPr/>
        </p:nvSpPr>
        <p:spPr>
          <a:xfrm rot="5400000">
            <a:off x="5182661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1D55465-CE25-778C-4B12-46527C5B27CD}"/>
              </a:ext>
            </a:extLst>
          </p:cNvPr>
          <p:cNvSpPr txBox="1"/>
          <p:nvPr/>
        </p:nvSpPr>
        <p:spPr>
          <a:xfrm rot="5400000">
            <a:off x="5942993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FA4C768-293D-B935-B1F7-51DA8359A0CC}"/>
              </a:ext>
            </a:extLst>
          </p:cNvPr>
          <p:cNvSpPr txBox="1"/>
          <p:nvPr/>
        </p:nvSpPr>
        <p:spPr>
          <a:xfrm rot="5400000">
            <a:off x="6007003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45CE393-3796-1A6B-B318-3EF4B49FF415}"/>
              </a:ext>
            </a:extLst>
          </p:cNvPr>
          <p:cNvSpPr txBox="1"/>
          <p:nvPr/>
        </p:nvSpPr>
        <p:spPr>
          <a:xfrm rot="5400000">
            <a:off x="6065917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382EDBA-F6A6-40C5-6735-1CFDC388724D}"/>
              </a:ext>
            </a:extLst>
          </p:cNvPr>
          <p:cNvSpPr txBox="1"/>
          <p:nvPr/>
        </p:nvSpPr>
        <p:spPr>
          <a:xfrm rot="5400000">
            <a:off x="4968760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9529816-E85F-D907-33F7-89C35F95FC40}"/>
              </a:ext>
            </a:extLst>
          </p:cNvPr>
          <p:cNvSpPr txBox="1"/>
          <p:nvPr/>
        </p:nvSpPr>
        <p:spPr>
          <a:xfrm rot="5400000">
            <a:off x="4909326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6C6861D-BBC5-6E91-E518-C3E8374EEF6C}"/>
              </a:ext>
            </a:extLst>
          </p:cNvPr>
          <p:cNvSpPr txBox="1"/>
          <p:nvPr/>
        </p:nvSpPr>
        <p:spPr>
          <a:xfrm rot="5400000">
            <a:off x="4668496" y="6195660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9437FF"/>
                </a:solidFill>
              </a:rPr>
              <a:t>PSEN1 R278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96ED0C3-4862-E42C-9B0E-9950FEBCB86C}"/>
              </a:ext>
            </a:extLst>
          </p:cNvPr>
          <p:cNvSpPr txBox="1"/>
          <p:nvPr/>
        </p:nvSpPr>
        <p:spPr>
          <a:xfrm rot="5400000">
            <a:off x="4845991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6EBE7E7-5C02-35D6-EBF6-909815B9E17E}"/>
              </a:ext>
            </a:extLst>
          </p:cNvPr>
          <p:cNvSpPr txBox="1"/>
          <p:nvPr/>
        </p:nvSpPr>
        <p:spPr>
          <a:xfrm rot="5400000">
            <a:off x="5947925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046DF20-7009-3950-B2C9-EED58D382DB9}"/>
              </a:ext>
            </a:extLst>
          </p:cNvPr>
          <p:cNvSpPr txBox="1"/>
          <p:nvPr/>
        </p:nvSpPr>
        <p:spPr>
          <a:xfrm rot="5400000">
            <a:off x="5337999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B7A989B-6AF1-8E46-845E-B24B6803ECCD}"/>
              </a:ext>
            </a:extLst>
          </p:cNvPr>
          <p:cNvSpPr txBox="1"/>
          <p:nvPr/>
        </p:nvSpPr>
        <p:spPr>
          <a:xfrm rot="5400000">
            <a:off x="5701797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881617E-9026-FF54-06D4-E7203153CCFB}"/>
              </a:ext>
            </a:extLst>
          </p:cNvPr>
          <p:cNvSpPr txBox="1"/>
          <p:nvPr/>
        </p:nvSpPr>
        <p:spPr>
          <a:xfrm rot="5400000">
            <a:off x="5643481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372BE0B-6C64-18EC-D2DA-F8C7D001559D}"/>
              </a:ext>
            </a:extLst>
          </p:cNvPr>
          <p:cNvSpPr txBox="1"/>
          <p:nvPr/>
        </p:nvSpPr>
        <p:spPr>
          <a:xfrm rot="5400000">
            <a:off x="5554927" y="6107494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 is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D4BE881-69C5-E5A1-D97D-3EBFAF76ECB1}"/>
              </a:ext>
            </a:extLst>
          </p:cNvPr>
          <p:cNvSpPr txBox="1"/>
          <p:nvPr/>
        </p:nvSpPr>
        <p:spPr>
          <a:xfrm rot="5400000">
            <a:off x="5890145" y="607383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solidFill>
                  <a:srgbClr val="008F51"/>
                </a:solidFill>
              </a:rPr>
              <a:t>Ctrl1</a:t>
            </a:r>
          </a:p>
        </p:txBody>
      </p:sp>
      <p:sp>
        <p:nvSpPr>
          <p:cNvPr id="62" name="Rounded Rectangle 61">
            <a:extLst>
              <a:ext uri="{FF2B5EF4-FFF2-40B4-BE49-F238E27FC236}">
                <a16:creationId xmlns:a16="http://schemas.microsoft.com/office/drawing/2014/main" id="{860432FC-DED0-DFA6-3FB4-B16F24B88C1E}"/>
              </a:ext>
            </a:extLst>
          </p:cNvPr>
          <p:cNvSpPr/>
          <p:nvPr/>
        </p:nvSpPr>
        <p:spPr>
          <a:xfrm>
            <a:off x="4804703" y="5939047"/>
            <a:ext cx="1399469" cy="108433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TIC</a:t>
            </a:r>
            <a:endParaRPr lang="en-GB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63" name="Rounded Rectangle 62">
            <a:extLst>
              <a:ext uri="{FF2B5EF4-FFF2-40B4-BE49-F238E27FC236}">
                <a16:creationId xmlns:a16="http://schemas.microsoft.com/office/drawing/2014/main" id="{E3A14D86-5505-E537-ED69-0CDD429875A0}"/>
              </a:ext>
            </a:extLst>
          </p:cNvPr>
          <p:cNvSpPr/>
          <p:nvPr/>
        </p:nvSpPr>
        <p:spPr>
          <a:xfrm>
            <a:off x="6218360" y="5939047"/>
            <a:ext cx="1399469" cy="108433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Untreated</a:t>
            </a:r>
            <a:endParaRPr lang="en-GB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BA64E3D-FFD6-649C-4433-789F820C603B}"/>
              </a:ext>
            </a:extLst>
          </p:cNvPr>
          <p:cNvSpPr txBox="1"/>
          <p:nvPr/>
        </p:nvSpPr>
        <p:spPr>
          <a:xfrm>
            <a:off x="5142011" y="3471540"/>
            <a:ext cx="3273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Samples ranked against published inflammatory signatures (GSEA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5A57BBA-1127-7A11-3A91-ABC25315FB84}"/>
              </a:ext>
            </a:extLst>
          </p:cNvPr>
          <p:cNvSpPr txBox="1"/>
          <p:nvPr/>
        </p:nvSpPr>
        <p:spPr>
          <a:xfrm>
            <a:off x="660654" y="3932262"/>
            <a:ext cx="416331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b="1" u="sng" dirty="0"/>
              <a:t>Rank</a:t>
            </a:r>
          </a:p>
          <a:p>
            <a:pPr algn="r"/>
            <a:r>
              <a:rPr lang="en-GB" sz="800" dirty="0"/>
              <a:t>NEMETH_INFLAMMATORY_RESPONSE_LPS_UP </a:t>
            </a:r>
          </a:p>
          <a:p>
            <a:pPr algn="r"/>
            <a:r>
              <a:rPr lang="en-GB" sz="800" dirty="0"/>
              <a:t>OKUMURA_INFLAMMATORY_RESPONSE_LPS </a:t>
            </a:r>
          </a:p>
          <a:p>
            <a:pPr algn="r"/>
            <a:r>
              <a:rPr lang="en-GB" sz="800" dirty="0"/>
              <a:t>REACTOME_DEX_H_BOX_HELICASES_ACTIVATE_TYPE_I_IFN_AND_INFLAMMATORY_CYTOKINE </a:t>
            </a:r>
          </a:p>
          <a:p>
            <a:pPr algn="r"/>
            <a:r>
              <a:rPr lang="en-GB" sz="800" dirty="0"/>
              <a:t>SEKI_INFLAMMATORY_RESPONSE_LPS_UP </a:t>
            </a:r>
          </a:p>
          <a:p>
            <a:pPr algn="r"/>
            <a:r>
              <a:rPr lang="en-GB" sz="800" dirty="0"/>
              <a:t>WP_CELLS_AND_MOLECULES_INVOLVED_IN_LOCAL_ACUTE_INFLAMMATORY_RESPONSE </a:t>
            </a:r>
          </a:p>
          <a:p>
            <a:pPr algn="r"/>
            <a:r>
              <a:rPr lang="en-GB" sz="800" dirty="0"/>
              <a:t>WP_CYTOKINES_AND_INFLAMMATORY_RESPONSE </a:t>
            </a:r>
          </a:p>
          <a:p>
            <a:pPr algn="r"/>
            <a:r>
              <a:rPr lang="en-GB" sz="800" dirty="0"/>
              <a:t>WP_INFLAMMATORY_BOWEL_DISEASE_SIGNALING </a:t>
            </a:r>
          </a:p>
          <a:p>
            <a:pPr algn="r"/>
            <a:r>
              <a:rPr lang="en-GB" sz="800" dirty="0"/>
              <a:t>WP_INFLAMMATORY_RESPONSE_PATHWAY </a:t>
            </a:r>
          </a:p>
          <a:p>
            <a:pPr algn="r"/>
            <a:r>
              <a:rPr lang="en-GB" sz="800" dirty="0"/>
              <a:t>WP_OVERVIEW_OF_PROINFLAMMATORY_AND_PROFIBROTIC_MEDIATORS </a:t>
            </a:r>
          </a:p>
          <a:p>
            <a:pPr algn="r"/>
            <a:r>
              <a:rPr lang="en-GB" sz="800" dirty="0"/>
              <a:t>WP_VITAMIN_D_IN_INFLAMMATORY_DISEASES </a:t>
            </a:r>
          </a:p>
          <a:p>
            <a:pPr algn="r"/>
            <a:r>
              <a:rPr lang="en-GB" sz="800" dirty="0"/>
              <a:t>WUNDER_INFLAMMATORY_RESPONSE_AND_CHOLESTEROL_UP </a:t>
            </a:r>
          </a:p>
          <a:p>
            <a:pPr algn="r"/>
            <a:r>
              <a:rPr lang="en-GB" sz="800" dirty="0"/>
              <a:t>ZHOU_INFLAMMATORY_RESPONSE_FIMA_UP </a:t>
            </a:r>
          </a:p>
          <a:p>
            <a:pPr algn="r"/>
            <a:r>
              <a:rPr lang="en-GB" sz="800" dirty="0"/>
              <a:t>ZHOU_INFLAMMATORY_RESPONSE_LIVE_UP </a:t>
            </a:r>
          </a:p>
          <a:p>
            <a:pPr algn="r"/>
            <a:r>
              <a:rPr lang="en-GB" sz="800" dirty="0"/>
              <a:t>ZHOU_INFLAMMATORY_RESPONSE_LPS_UP </a:t>
            </a:r>
          </a:p>
        </p:txBody>
      </p:sp>
    </p:spTree>
    <p:extLst>
      <p:ext uri="{BB962C8B-B14F-4D97-AF65-F5344CB8AC3E}">
        <p14:creationId xmlns:p14="http://schemas.microsoft.com/office/powerpoint/2010/main" val="22036101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14E9F40-811A-911C-F5D0-78983FC711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2698"/>
            <a:ext cx="9909371" cy="63853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EBEA647-87D8-F8B1-C636-D3ED923FA87C}"/>
              </a:ext>
            </a:extLst>
          </p:cNvPr>
          <p:cNvSpPr txBox="1"/>
          <p:nvPr/>
        </p:nvSpPr>
        <p:spPr>
          <a:xfrm>
            <a:off x="169817" y="70409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5</a:t>
            </a:r>
          </a:p>
        </p:txBody>
      </p:sp>
    </p:spTree>
    <p:extLst>
      <p:ext uri="{BB962C8B-B14F-4D97-AF65-F5344CB8AC3E}">
        <p14:creationId xmlns:p14="http://schemas.microsoft.com/office/powerpoint/2010/main" val="3258705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DF99D2-21E6-0CEF-CAF4-A84E6D4A3C57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6</a:t>
            </a:r>
          </a:p>
        </p:txBody>
      </p:sp>
      <p:pic>
        <p:nvPicPr>
          <p:cNvPr id="6" name="Picture 5" descr="A graph and diagram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F14BD216-71A8-2340-B90D-874FE38DD3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573107"/>
            <a:ext cx="7772400" cy="310896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646787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B656EB8-EC9A-D156-C257-E07A911D4D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800" y="2571750"/>
            <a:ext cx="2664604" cy="254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0DC031-4E13-7981-FFC5-EF0E15FBC4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7566" y="2571750"/>
            <a:ext cx="2750868" cy="254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EC0DCBF-688E-4DC7-76F6-1C1F2F0517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82596" y="2571750"/>
            <a:ext cx="2664604" cy="25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ED4C805-E094-A631-163B-62BB768B6734}"/>
              </a:ext>
            </a:extLst>
          </p:cNvPr>
          <p:cNvSpPr txBox="1"/>
          <p:nvPr/>
        </p:nvSpPr>
        <p:spPr>
          <a:xfrm>
            <a:off x="0" y="4929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7</a:t>
            </a:r>
          </a:p>
        </p:txBody>
      </p:sp>
    </p:spTree>
    <p:extLst>
      <p:ext uri="{BB962C8B-B14F-4D97-AF65-F5344CB8AC3E}">
        <p14:creationId xmlns:p14="http://schemas.microsoft.com/office/powerpoint/2010/main" val="5393747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3C30D00-30E6-AF80-BE3F-AD487E6B95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386" y="4910272"/>
            <a:ext cx="1674720" cy="171381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08FC227-766D-8814-6530-8C654572C5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1464" y="4911676"/>
            <a:ext cx="1713818" cy="171381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8ED6297-3B44-A13A-E5E0-2243F46257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71640" y="4910272"/>
            <a:ext cx="1674720" cy="171381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BA3489C-A8D8-1EE3-766F-13EBF496A37E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719280" y="452466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307C0CE-11FD-2925-6746-4F2DA32CC6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99834" y="452601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041CF39-3691-2AB5-453F-09F97230D9B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8556" y="454296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4CF7B5-8147-D5E3-E146-F2D2DD5B750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84767" y="452466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6ED05D5-C2F6-2F63-2DB3-6428C98CC4C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11996" y="2662181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D3366BC-6C9E-9A12-2FF0-F7C6F2CDC802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900613" y="2662181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49C90A0-58CB-7D38-1C73-A9E86278EEB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8556" y="2682351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B9E09DD-AB12-7C36-A590-3C0A3DD94D96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7084852" y="2682216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928DDE0-4E55-600B-D3B8-CFD2A226826B}"/>
              </a:ext>
            </a:extLst>
          </p:cNvPr>
          <p:cNvSpPr txBox="1"/>
          <p:nvPr/>
        </p:nvSpPr>
        <p:spPr>
          <a:xfrm>
            <a:off x="0" y="4929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uppl</a:t>
            </a:r>
            <a:r>
              <a:rPr lang="en-GB" dirty="0"/>
              <a:t> Fig 8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25976A4-04B0-C3C6-0885-211F0D3CE7B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419673" y="5321857"/>
            <a:ext cx="2158812" cy="1302233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2F0F4E6-F3C7-079F-9E9F-A6DDFE7DCBD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651798" y="5321857"/>
            <a:ext cx="2158811" cy="1302232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FFB6CA3-0CC9-39CC-FA76-EF1316C0419E}"/>
              </a:ext>
            </a:extLst>
          </p:cNvPr>
          <p:cNvSpPr txBox="1"/>
          <p:nvPr/>
        </p:nvSpPr>
        <p:spPr>
          <a:xfrm>
            <a:off x="6032051" y="4952525"/>
            <a:ext cx="76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Expt</a:t>
            </a:r>
            <a:r>
              <a:rPr lang="en-GB" dirty="0"/>
              <a:t>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F1C7E3-83D3-3D2D-4360-08F7349CADC6}"/>
              </a:ext>
            </a:extLst>
          </p:cNvPr>
          <p:cNvSpPr txBox="1"/>
          <p:nvPr/>
        </p:nvSpPr>
        <p:spPr>
          <a:xfrm>
            <a:off x="8245799" y="4952525"/>
            <a:ext cx="76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Expt</a:t>
            </a:r>
            <a:r>
              <a:rPr lang="en-GB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25500484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806858-BFA4-7A7F-29FE-F882B0548DD5}"/>
              </a:ext>
            </a:extLst>
          </p:cNvPr>
          <p:cNvSpPr txBox="1"/>
          <p:nvPr/>
        </p:nvSpPr>
        <p:spPr>
          <a:xfrm>
            <a:off x="0" y="4929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uppl</a:t>
            </a:r>
            <a:r>
              <a:rPr lang="en-GB" dirty="0"/>
              <a:t> Fig 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B7CB20A-3B9F-614A-8499-A7828BE46756}"/>
              </a:ext>
            </a:extLst>
          </p:cNvPr>
          <p:cNvSpPr txBox="1"/>
          <p:nvPr/>
        </p:nvSpPr>
        <p:spPr>
          <a:xfrm>
            <a:off x="1465738" y="28024"/>
            <a:ext cx="3934767" cy="369332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Fig 2</a:t>
            </a:r>
          </a:p>
        </p:txBody>
      </p:sp>
      <p:pic>
        <p:nvPicPr>
          <p:cNvPr id="7" name="Picture 6" descr="A close-up of a white square&#10;&#10;Description automatically generated">
            <a:extLst>
              <a:ext uri="{FF2B5EF4-FFF2-40B4-BE49-F238E27FC236}">
                <a16:creationId xmlns:a16="http://schemas.microsoft.com/office/drawing/2014/main" id="{4096ADD1-22A2-44F6-9860-8DE8D5790D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9206" y="523178"/>
            <a:ext cx="1511300" cy="1282700"/>
          </a:xfrm>
          <a:prstGeom prst="rect">
            <a:avLst/>
          </a:prstGeom>
        </p:spPr>
      </p:pic>
      <p:pic>
        <p:nvPicPr>
          <p:cNvPr id="9" name="Picture 8" descr="A close-up of a vent&#10;&#10;Description automatically generated">
            <a:extLst>
              <a:ext uri="{FF2B5EF4-FFF2-40B4-BE49-F238E27FC236}">
                <a16:creationId xmlns:a16="http://schemas.microsoft.com/office/drawing/2014/main" id="{3E7E2B6E-ED52-17C0-A3BA-DB1DE36C17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9205" y="1890150"/>
            <a:ext cx="1511300" cy="1282700"/>
          </a:xfrm>
          <a:prstGeom prst="rect">
            <a:avLst/>
          </a:prstGeom>
        </p:spPr>
      </p:pic>
      <p:pic>
        <p:nvPicPr>
          <p:cNvPr id="11" name="Picture 10" descr="A close-up of a test&#10;&#10;Description automatically generated">
            <a:extLst>
              <a:ext uri="{FF2B5EF4-FFF2-40B4-BE49-F238E27FC236}">
                <a16:creationId xmlns:a16="http://schemas.microsoft.com/office/drawing/2014/main" id="{C631F50E-751A-82EB-20F8-1731A00274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89205" y="3246362"/>
            <a:ext cx="1511300" cy="1282700"/>
          </a:xfrm>
          <a:prstGeom prst="rect">
            <a:avLst/>
          </a:prstGeom>
        </p:spPr>
      </p:pic>
      <p:pic>
        <p:nvPicPr>
          <p:cNvPr id="13" name="Picture 12" descr="A square object with black spots&#10;&#10;Description automatically generated with medium confidence">
            <a:extLst>
              <a:ext uri="{FF2B5EF4-FFF2-40B4-BE49-F238E27FC236}">
                <a16:creationId xmlns:a16="http://schemas.microsoft.com/office/drawing/2014/main" id="{AD55C097-6D5E-6611-1EE9-2AED392106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7913" y="519028"/>
            <a:ext cx="1511300" cy="1282700"/>
          </a:xfrm>
          <a:prstGeom prst="rect">
            <a:avLst/>
          </a:prstGeom>
        </p:spPr>
      </p:pic>
      <p:pic>
        <p:nvPicPr>
          <p:cNvPr id="15" name="Picture 14" descr="A white square with black lines&#10;&#10;Description automatically generated">
            <a:extLst>
              <a:ext uri="{FF2B5EF4-FFF2-40B4-BE49-F238E27FC236}">
                <a16:creationId xmlns:a16="http://schemas.microsoft.com/office/drawing/2014/main" id="{371259E1-EB56-D091-42C3-202AE48F66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37912" y="3242212"/>
            <a:ext cx="1511300" cy="12827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94598F3-0F10-0DA9-5953-177C5DD4EC56}"/>
              </a:ext>
            </a:extLst>
          </p:cNvPr>
          <p:cNvSpPr txBox="1"/>
          <p:nvPr/>
        </p:nvSpPr>
        <p:spPr>
          <a:xfrm rot="16200000">
            <a:off x="978278" y="1006490"/>
            <a:ext cx="1282698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EN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D1BFBF-C4CF-3426-E580-596B1016C94C}"/>
              </a:ext>
            </a:extLst>
          </p:cNvPr>
          <p:cNvSpPr txBox="1"/>
          <p:nvPr/>
        </p:nvSpPr>
        <p:spPr>
          <a:xfrm rot="16200000">
            <a:off x="978276" y="3729674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1F0D6B5-2F4A-4710-C24F-01B68007590E}"/>
              </a:ext>
            </a:extLst>
          </p:cNvPr>
          <p:cNvSpPr txBox="1"/>
          <p:nvPr/>
        </p:nvSpPr>
        <p:spPr>
          <a:xfrm rot="16200000">
            <a:off x="3123976" y="3729673"/>
            <a:ext cx="1282700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ct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7454E48-CFBD-FBC6-144B-E8FFB234BAEB}"/>
              </a:ext>
            </a:extLst>
          </p:cNvPr>
          <p:cNvSpPr txBox="1"/>
          <p:nvPr/>
        </p:nvSpPr>
        <p:spPr>
          <a:xfrm rot="16200000">
            <a:off x="3016254" y="2262435"/>
            <a:ext cx="1282701" cy="52322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PP </a:t>
            </a:r>
          </a:p>
          <a:p>
            <a:pPr algn="ctr"/>
            <a:r>
              <a:rPr lang="en-GB" sz="1400" dirty="0"/>
              <a:t>long exposu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657C5C0-9B3A-3AA2-CB3B-DBF458BEEB61}"/>
              </a:ext>
            </a:extLst>
          </p:cNvPr>
          <p:cNvSpPr txBox="1"/>
          <p:nvPr/>
        </p:nvSpPr>
        <p:spPr>
          <a:xfrm rot="16200000">
            <a:off x="3016255" y="901169"/>
            <a:ext cx="1282702" cy="52322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PP </a:t>
            </a:r>
          </a:p>
          <a:p>
            <a:pPr algn="ctr"/>
            <a:r>
              <a:rPr lang="en-GB" sz="1400" dirty="0"/>
              <a:t>short exposur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3F8F11-9960-D059-3E2E-94F33D7A6FC6}"/>
              </a:ext>
            </a:extLst>
          </p:cNvPr>
          <p:cNvSpPr txBox="1"/>
          <p:nvPr/>
        </p:nvSpPr>
        <p:spPr>
          <a:xfrm>
            <a:off x="5789378" y="28024"/>
            <a:ext cx="3915855" cy="369332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Fig 4</a:t>
            </a:r>
          </a:p>
        </p:txBody>
      </p:sp>
      <p:pic>
        <p:nvPicPr>
          <p:cNvPr id="23" name="Picture 22" descr="A black and white photo of a square&#10;&#10;Description automatically generated">
            <a:extLst>
              <a:ext uri="{FF2B5EF4-FFF2-40B4-BE49-F238E27FC236}">
                <a16:creationId xmlns:a16="http://schemas.microsoft.com/office/drawing/2014/main" id="{9FABA7C5-0AAA-5FE8-CCC4-DB3997953A1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33327" y="513608"/>
            <a:ext cx="1511300" cy="1282700"/>
          </a:xfrm>
          <a:prstGeom prst="rect">
            <a:avLst/>
          </a:prstGeom>
        </p:spPr>
      </p:pic>
      <p:pic>
        <p:nvPicPr>
          <p:cNvPr id="25" name="Picture 24" descr="A close-up of a test&#10;&#10;Description automatically generated">
            <a:extLst>
              <a:ext uri="{FF2B5EF4-FFF2-40B4-BE49-F238E27FC236}">
                <a16:creationId xmlns:a16="http://schemas.microsoft.com/office/drawing/2014/main" id="{89589B68-166B-7769-85EF-0CAA7779B70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33327" y="1882696"/>
            <a:ext cx="1511300" cy="1282700"/>
          </a:xfrm>
          <a:prstGeom prst="rect">
            <a:avLst/>
          </a:prstGeom>
        </p:spPr>
      </p:pic>
      <p:pic>
        <p:nvPicPr>
          <p:cNvPr id="27" name="Picture 26" descr="A black and white photo of a square&#10;&#10;Description automatically generated">
            <a:extLst>
              <a:ext uri="{FF2B5EF4-FFF2-40B4-BE49-F238E27FC236}">
                <a16:creationId xmlns:a16="http://schemas.microsoft.com/office/drawing/2014/main" id="{BCFC2A9B-20AD-3ACC-6B27-80667884D22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33327" y="3251785"/>
            <a:ext cx="1511300" cy="1282700"/>
          </a:xfrm>
          <a:prstGeom prst="rect">
            <a:avLst/>
          </a:prstGeom>
        </p:spPr>
      </p:pic>
      <p:pic>
        <p:nvPicPr>
          <p:cNvPr id="29" name="Picture 28" descr="A black dotted line on a white background&#10;&#10;Description automatically generated">
            <a:extLst>
              <a:ext uri="{FF2B5EF4-FFF2-40B4-BE49-F238E27FC236}">
                <a16:creationId xmlns:a16="http://schemas.microsoft.com/office/drawing/2014/main" id="{E8D9E785-379C-91A4-D3DF-7E6C9CB83BC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33327" y="4620874"/>
            <a:ext cx="1511300" cy="1282700"/>
          </a:xfrm>
          <a:prstGeom prst="rect">
            <a:avLst/>
          </a:prstGeom>
        </p:spPr>
      </p:pic>
      <p:pic>
        <p:nvPicPr>
          <p:cNvPr id="31" name="Picture 30" descr="A white square with black dots&#10;&#10;Description automatically generated">
            <a:extLst>
              <a:ext uri="{FF2B5EF4-FFF2-40B4-BE49-F238E27FC236}">
                <a16:creationId xmlns:a16="http://schemas.microsoft.com/office/drawing/2014/main" id="{FF6AA729-C9C4-8860-BDA4-0628F24F3AE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93933" y="513608"/>
            <a:ext cx="1511300" cy="1282700"/>
          </a:xfrm>
          <a:prstGeom prst="rect">
            <a:avLst/>
          </a:prstGeom>
        </p:spPr>
      </p:pic>
      <p:pic>
        <p:nvPicPr>
          <p:cNvPr id="33" name="Picture 32" descr="A close-up of a white square&#10;&#10;Description automatically generated">
            <a:extLst>
              <a:ext uri="{FF2B5EF4-FFF2-40B4-BE49-F238E27FC236}">
                <a16:creationId xmlns:a16="http://schemas.microsoft.com/office/drawing/2014/main" id="{A4858D6C-7076-D0E3-8151-A0366251636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193933" y="1886783"/>
            <a:ext cx="1511300" cy="1282700"/>
          </a:xfrm>
          <a:prstGeom prst="rect">
            <a:avLst/>
          </a:prstGeom>
        </p:spPr>
      </p:pic>
      <p:pic>
        <p:nvPicPr>
          <p:cNvPr id="35" name="Picture 34" descr="A close-up of a test&#10;&#10;Description automatically generated">
            <a:extLst>
              <a:ext uri="{FF2B5EF4-FFF2-40B4-BE49-F238E27FC236}">
                <a16:creationId xmlns:a16="http://schemas.microsoft.com/office/drawing/2014/main" id="{C2F04113-B6CC-1C66-34FD-BA9BB4247F0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193933" y="3255872"/>
            <a:ext cx="1511300" cy="1282700"/>
          </a:xfrm>
          <a:prstGeom prst="rect">
            <a:avLst/>
          </a:prstGeom>
        </p:spPr>
      </p:pic>
      <p:pic>
        <p:nvPicPr>
          <p:cNvPr id="37" name="Picture 36" descr="A close-up of a test&#10;&#10;Description automatically generated">
            <a:extLst>
              <a:ext uri="{FF2B5EF4-FFF2-40B4-BE49-F238E27FC236}">
                <a16:creationId xmlns:a16="http://schemas.microsoft.com/office/drawing/2014/main" id="{1571F996-30B8-D387-2C6A-4C61495AE16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193933" y="4624961"/>
            <a:ext cx="1511300" cy="1282700"/>
          </a:xfrm>
          <a:prstGeom prst="rect">
            <a:avLst/>
          </a:prstGeom>
        </p:spPr>
      </p:pic>
      <p:pic>
        <p:nvPicPr>
          <p:cNvPr id="39" name="Picture 38" descr="A black dotted line on a white background&#10;&#10;Description automatically generated">
            <a:extLst>
              <a:ext uri="{FF2B5EF4-FFF2-40B4-BE49-F238E27FC236}">
                <a16:creationId xmlns:a16="http://schemas.microsoft.com/office/drawing/2014/main" id="{30795569-92FB-E8F7-DFC6-E923D93B8FC3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b="31967"/>
          <a:stretch/>
        </p:blipFill>
        <p:spPr>
          <a:xfrm>
            <a:off x="8193933" y="5964078"/>
            <a:ext cx="1511300" cy="872656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F07CE067-DF67-8651-6175-AF04F8C4B467}"/>
              </a:ext>
            </a:extLst>
          </p:cNvPr>
          <p:cNvSpPr txBox="1"/>
          <p:nvPr/>
        </p:nvSpPr>
        <p:spPr>
          <a:xfrm rot="16200000">
            <a:off x="5301919" y="5108336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cti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ECD8A40-A5DB-B8D9-A13B-64C254AEC546}"/>
              </a:ext>
            </a:extLst>
          </p:cNvPr>
          <p:cNvSpPr txBox="1"/>
          <p:nvPr/>
        </p:nvSpPr>
        <p:spPr>
          <a:xfrm rot="16200000">
            <a:off x="7551309" y="6242911"/>
            <a:ext cx="872658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Act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E2D03DC-AA22-2E14-2ED8-ED9F84AAB2EF}"/>
              </a:ext>
            </a:extLst>
          </p:cNvPr>
          <p:cNvSpPr txBox="1"/>
          <p:nvPr/>
        </p:nvSpPr>
        <p:spPr>
          <a:xfrm rot="16200000">
            <a:off x="5301918" y="3746700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/>
              <a:t>pMAPK</a:t>
            </a:r>
            <a:endParaRPr lang="en-GB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499B38E-2187-3139-074C-E129096AA56E}"/>
              </a:ext>
            </a:extLst>
          </p:cNvPr>
          <p:cNvSpPr txBox="1"/>
          <p:nvPr/>
        </p:nvSpPr>
        <p:spPr>
          <a:xfrm rot="16200000">
            <a:off x="5301917" y="2370157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/>
              <a:t>pNFKB</a:t>
            </a:r>
            <a:endParaRPr lang="en-GB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E584551-71BF-9503-AF95-A08D08D73F91}"/>
              </a:ext>
            </a:extLst>
          </p:cNvPr>
          <p:cNvSpPr txBox="1"/>
          <p:nvPr/>
        </p:nvSpPr>
        <p:spPr>
          <a:xfrm rot="16200000">
            <a:off x="5301917" y="1008522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TAT2 pSTAT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9AC6168-6071-DBF6-5E04-66618ECEC853}"/>
              </a:ext>
            </a:extLst>
          </p:cNvPr>
          <p:cNvSpPr txBox="1"/>
          <p:nvPr/>
        </p:nvSpPr>
        <p:spPr>
          <a:xfrm rot="16200000">
            <a:off x="7346289" y="5115786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/>
              <a:t>pMAPK</a:t>
            </a:r>
            <a:endParaRPr lang="en-GB"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5481061-51A9-F4F3-EFCC-315BCFFAD0B7}"/>
              </a:ext>
            </a:extLst>
          </p:cNvPr>
          <p:cNvSpPr txBox="1"/>
          <p:nvPr/>
        </p:nvSpPr>
        <p:spPr>
          <a:xfrm rot="16200000">
            <a:off x="7346289" y="3739243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/>
              <a:t>pNFKB</a:t>
            </a:r>
            <a:endParaRPr lang="en-GB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C21D113-1552-1AA0-1AA9-E09233DFF7E7}"/>
              </a:ext>
            </a:extLst>
          </p:cNvPr>
          <p:cNvSpPr txBox="1"/>
          <p:nvPr/>
        </p:nvSpPr>
        <p:spPr>
          <a:xfrm rot="16200000">
            <a:off x="7346289" y="1013898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TAT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8957CC1-06F3-4E00-8E86-E310C1E5E47B}"/>
              </a:ext>
            </a:extLst>
          </p:cNvPr>
          <p:cNvSpPr txBox="1"/>
          <p:nvPr/>
        </p:nvSpPr>
        <p:spPr>
          <a:xfrm rot="16200000">
            <a:off x="7346289" y="2358287"/>
            <a:ext cx="1282699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TAT3</a:t>
            </a:r>
          </a:p>
        </p:txBody>
      </p:sp>
      <p:pic>
        <p:nvPicPr>
          <p:cNvPr id="3" name="Picture 2" descr="A green square object with a black background&#10;&#10;Description automatically generated">
            <a:extLst>
              <a:ext uri="{FF2B5EF4-FFF2-40B4-BE49-F238E27FC236}">
                <a16:creationId xmlns:a16="http://schemas.microsoft.com/office/drawing/2014/main" id="{1D7F4FA2-A536-F615-A3D5-7209F28F641A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0406" t="27216" r="14938" b="16173"/>
          <a:stretch/>
        </p:blipFill>
        <p:spPr>
          <a:xfrm>
            <a:off x="1837912" y="5706901"/>
            <a:ext cx="1511300" cy="11230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493164-F67C-BB20-9DA0-91A5FBCFE39D}"/>
              </a:ext>
            </a:extLst>
          </p:cNvPr>
          <p:cNvSpPr txBox="1"/>
          <p:nvPr/>
        </p:nvSpPr>
        <p:spPr>
          <a:xfrm>
            <a:off x="1465737" y="5269674"/>
            <a:ext cx="1883475" cy="369332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Fig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F0C6D7-151F-C038-1C7A-EF1CD270CEDB}"/>
              </a:ext>
            </a:extLst>
          </p:cNvPr>
          <p:cNvSpPr txBox="1"/>
          <p:nvPr/>
        </p:nvSpPr>
        <p:spPr>
          <a:xfrm rot="16200000">
            <a:off x="1060926" y="6114548"/>
            <a:ext cx="1123076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FF0000"/>
                </a:solidFill>
              </a:rPr>
              <a:t>sAPPβ</a:t>
            </a:r>
            <a:r>
              <a:rPr lang="en-GB" sz="1400" dirty="0"/>
              <a:t> </a:t>
            </a:r>
            <a:r>
              <a:rPr lang="en-GB" sz="1400" dirty="0">
                <a:solidFill>
                  <a:srgbClr val="00B050"/>
                </a:solidFill>
              </a:rPr>
              <a:t>sAPP</a:t>
            </a:r>
          </a:p>
        </p:txBody>
      </p:sp>
    </p:spTree>
    <p:extLst>
      <p:ext uri="{BB962C8B-B14F-4D97-AF65-F5344CB8AC3E}">
        <p14:creationId xmlns:p14="http://schemas.microsoft.com/office/powerpoint/2010/main" val="874222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271</TotalTime>
  <Words>385</Words>
  <Application>Microsoft Macintosh PowerPoint</Application>
  <PresentationFormat>A4 Paper (210x297 mm)</PresentationFormat>
  <Paragraphs>151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</dc:creator>
  <cp:lastModifiedBy>Charlie</cp:lastModifiedBy>
  <cp:revision>3</cp:revision>
  <dcterms:created xsi:type="dcterms:W3CDTF">2024-02-05T11:16:06Z</dcterms:created>
  <dcterms:modified xsi:type="dcterms:W3CDTF">2025-05-21T08:28:18Z</dcterms:modified>
</cp:coreProperties>
</file>